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0.xml" ContentType="application/vnd.openxmlformats-officedocument.drawingml.chart+xml"/>
  <Override PartName="/ppt/charts/chart1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style1.xml" ContentType="application/vnd.ms-office.chartstyle+xml"/>
  <Override PartName="/ppt/charts/colors1.xml" ContentType="application/vnd.ms-office.chartcolorstyle+xml"/>
  <Override PartName="/ppt/charts/style2.xml" ContentType="application/vnd.ms-office.chartstyle+xml"/>
  <Override PartName="/ppt/charts/colors2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80" r:id="rId2"/>
    <p:sldId id="278" r:id="rId3"/>
    <p:sldId id="270" r:id="rId4"/>
    <p:sldId id="274" r:id="rId5"/>
    <p:sldId id="259" r:id="rId6"/>
    <p:sldId id="271" r:id="rId7"/>
    <p:sldId id="279" r:id="rId8"/>
  </p:sldIdLst>
  <p:sldSz cx="9144000" cy="6858000" type="screen4x3"/>
  <p:notesSz cx="6858000" cy="9144000"/>
  <p:defaultTextStyle>
    <a:lvl1pPr algn="ctr" defTabSz="410751">
      <a:defRPr sz="2500">
        <a:latin typeface="+mn-lt"/>
        <a:ea typeface="+mn-ea"/>
        <a:cs typeface="+mn-cs"/>
        <a:sym typeface="Helvetica Light"/>
      </a:defRPr>
    </a:lvl1pPr>
    <a:lvl2pPr indent="160729" algn="ctr" defTabSz="410751">
      <a:defRPr sz="2500">
        <a:latin typeface="+mn-lt"/>
        <a:ea typeface="+mn-ea"/>
        <a:cs typeface="+mn-cs"/>
        <a:sym typeface="Helvetica Light"/>
      </a:defRPr>
    </a:lvl2pPr>
    <a:lvl3pPr indent="321457" algn="ctr" defTabSz="410751">
      <a:defRPr sz="2500">
        <a:latin typeface="+mn-lt"/>
        <a:ea typeface="+mn-ea"/>
        <a:cs typeface="+mn-cs"/>
        <a:sym typeface="Helvetica Light"/>
      </a:defRPr>
    </a:lvl3pPr>
    <a:lvl4pPr indent="482186" algn="ctr" defTabSz="410751">
      <a:defRPr sz="2500">
        <a:latin typeface="+mn-lt"/>
        <a:ea typeface="+mn-ea"/>
        <a:cs typeface="+mn-cs"/>
        <a:sym typeface="Helvetica Light"/>
      </a:defRPr>
    </a:lvl4pPr>
    <a:lvl5pPr indent="642915" algn="ctr" defTabSz="410751">
      <a:defRPr sz="2500">
        <a:latin typeface="+mn-lt"/>
        <a:ea typeface="+mn-ea"/>
        <a:cs typeface="+mn-cs"/>
        <a:sym typeface="Helvetica Light"/>
      </a:defRPr>
    </a:lvl5pPr>
    <a:lvl6pPr indent="803643" algn="ctr" defTabSz="410751">
      <a:defRPr sz="2500">
        <a:latin typeface="+mn-lt"/>
        <a:ea typeface="+mn-ea"/>
        <a:cs typeface="+mn-cs"/>
        <a:sym typeface="Helvetica Light"/>
      </a:defRPr>
    </a:lvl6pPr>
    <a:lvl7pPr indent="964372" algn="ctr" defTabSz="410751">
      <a:defRPr sz="2500">
        <a:latin typeface="+mn-lt"/>
        <a:ea typeface="+mn-ea"/>
        <a:cs typeface="+mn-cs"/>
        <a:sym typeface="Helvetica Light"/>
      </a:defRPr>
    </a:lvl7pPr>
    <a:lvl8pPr indent="1125101" algn="ctr" defTabSz="410751">
      <a:defRPr sz="2500">
        <a:latin typeface="+mn-lt"/>
        <a:ea typeface="+mn-ea"/>
        <a:cs typeface="+mn-cs"/>
        <a:sym typeface="Helvetica Light"/>
      </a:defRPr>
    </a:lvl8pPr>
    <a:lvl9pPr indent="1285829" algn="ctr" defTabSz="410751">
      <a:defRPr sz="2500">
        <a:latin typeface="+mn-lt"/>
        <a:ea typeface="+mn-ea"/>
        <a:cs typeface="+mn-cs"/>
        <a:sym typeface="Helvetica Light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729"/>
  </p:normalViewPr>
  <p:slideViewPr>
    <p:cSldViewPr snapToGrid="0" snapToObjects="1">
      <p:cViewPr>
        <p:scale>
          <a:sx n="106" d="100"/>
          <a:sy n="106" d="100"/>
        </p:scale>
        <p:origin x="-976" y="-26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viewProps" Target="viewProps.xml"/><Relationship Id="rId12" Type="http://schemas.openxmlformats.org/officeDocument/2006/relationships/theme" Target="theme/theme1.xml"/><Relationship Id="rId13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printerSettings" Target="printerSettings/printerSettings1.bin"/><Relationship Id="rId10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ugba:Desktop:EZGI%20K%20PAPER%20FINAL%20SUBMISSION:Ezgi%20paper%20manuscript:Kaya%20et%20al.%20Oncotarget%20revision%20v1:Data%20for%20revisions%20from%20TBO%20lab:Ahmet:01.06.17-HRK%20o-e%20cells-A172-U373_HRK%20paper_AC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zgi\Desktop\Master%20of%20Science\Results\Ahmetten\T98G,%20LN18,%20A172-Bcl2-BclxL-GFP-28.02.14.xlsx" TargetMode="External"/><Relationship Id="rId2" Type="http://schemas.microsoft.com/office/2011/relationships/chartStyle" Target="style1.xml"/><Relationship Id="rId3" Type="http://schemas.microsoft.com/office/2011/relationships/chartColorStyle" Target="colors1.xm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zgi\Desktop\210516%20CTG%20bcl2%20bckxl.xlsx" TargetMode="External"/><Relationship Id="rId2" Type="http://schemas.microsoft.com/office/2011/relationships/chartStyle" Target="style2.xml"/><Relationship Id="rId3" Type="http://schemas.microsoft.com/office/2011/relationships/chartColorStyle" Target="colors2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ugba:Desktop:EZGI%20K%20PAPER%20FINAL%20SUBMISSION:Ezgi%20paper%20manuscript:Kaya%20et%20al.%20Oncotarget%20revision%20v1:Data%20for%20revisions%20from%20TBO%20lab:Ahmet:01.06.17-HRK%20o-e%20cells-LN18-U87MG_HRK%20paper_AC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ugba:Desktop:EZGI%20K%20PAPER%20FINAL%20SUBMISSION:Ezgi%20paper%20manuscript:Kaya%20et%20al.%20Oncotarget%20revision%20v1:Data%20for%20revisions%20from%20TBO%20lab:Ahmet:01.06.17-HRK%20o-e%20cells-LN18-U87MG_HRK%20paper_AC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ugba:Desktop:EZGI%20K%20PAPER%20FINAL%20SUBMISSION:Ezgi%20paper%20manuscript:Kaya%20et%20al.%20Oncotarget%20revision%20v1:Data%20for%20revisions%20from%20TBO%20lab:Ahmet:01.06.17-HRK%20o-e%20cells-A172-U373_HRK%20paper_AC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ezgi\Desktop\EK-AC-U87FMC-4.11.15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ugba:Desktop:Ezgi%20paper%20manuscript:Kaya%20et%20al.%20Oncotarget%20revision%20v1:Data%20for%20revisions%20from%20TBO%20lab:5-aza%20(48h)--HRK%20in%20A172_LN18_U87_U373-%2012.02.17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ugba:Desktop:Ezgi%20paper%20manuscript:Kaya%20et%20al.%20Oncotarget%20revision%20v1:Data%20for%20revisions%20from%20TBO%20lab:5-aza%20(48h)--HRK%20in%20A172_LN18_U87_U373-%2012.02.17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ugba:Desktop:Ezgi%20paper%20manuscript:Kaya%20et%20al.%20Oncotarget%20revision%20v1:Data%20for%20revisions%20from%20TBO%20lab:5-aza%20(48h)--HRK%20in%20A172_LN18_U87_U373-%2012.02.17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Tugba:Desktop:Ezgi%20paper%20manuscript:Kaya%20et%20al.%20Oncotarget%20revision%20v1:Data%20for%20revisions%20from%20TBO%20lab:5-aza%20(48h)--HRK%20in%20A172_LN18_U87_U373-%2012.02.1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nalyze!$T$139</c:f>
              <c:strCache>
                <c:ptCount val="1"/>
                <c:pt idx="0">
                  <c:v>A172-Control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ze!$U$144:$AA$144</c:f>
                <c:numCache>
                  <c:formatCode>General</c:formatCode>
                  <c:ptCount val="7"/>
                  <c:pt idx="0">
                    <c:v>0.112554377878145</c:v>
                  </c:pt>
                  <c:pt idx="1">
                    <c:v>0.0222853656915579</c:v>
                  </c:pt>
                  <c:pt idx="2">
                    <c:v>0.126831964677902</c:v>
                  </c:pt>
                  <c:pt idx="3">
                    <c:v>0.166923976511198</c:v>
                  </c:pt>
                  <c:pt idx="4">
                    <c:v>0.280505449404598</c:v>
                  </c:pt>
                  <c:pt idx="5">
                    <c:v>0.0182093124878877</c:v>
                  </c:pt>
                  <c:pt idx="6">
                    <c:v>0.215610851933906</c:v>
                  </c:pt>
                </c:numCache>
              </c:numRef>
            </c:plus>
            <c:minus>
              <c:numRef>
                <c:f>Analyze!$U$149:$AA$149</c:f>
                <c:numCache>
                  <c:formatCode>General</c:formatCode>
                  <c:ptCount val="7"/>
                  <c:pt idx="0">
                    <c:v>0.101167529530383</c:v>
                  </c:pt>
                  <c:pt idx="1">
                    <c:v>0.0217995546443955</c:v>
                  </c:pt>
                  <c:pt idx="2">
                    <c:v>0.112556236114721</c:v>
                  </c:pt>
                  <c:pt idx="3">
                    <c:v>0.143046145139855</c:v>
                  </c:pt>
                  <c:pt idx="4">
                    <c:v>0.219058380060021</c:v>
                  </c:pt>
                  <c:pt idx="5">
                    <c:v>0.017883663274887</c:v>
                  </c:pt>
                  <c:pt idx="6">
                    <c:v>0.17736831782218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ze!$U$138:$Z$138</c:f>
              <c:strCache>
                <c:ptCount val="6"/>
                <c:pt idx="0">
                  <c:v>Bad</c:v>
                </c:pt>
                <c:pt idx="1">
                  <c:v>Bak</c:v>
                </c:pt>
                <c:pt idx="2">
                  <c:v>Bim</c:v>
                </c:pt>
                <c:pt idx="3">
                  <c:v>Bik</c:v>
                </c:pt>
                <c:pt idx="4">
                  <c:v>Bcl-2</c:v>
                </c:pt>
                <c:pt idx="5">
                  <c:v>Bcl-xL</c:v>
                </c:pt>
              </c:strCache>
            </c:strRef>
          </c:cat>
          <c:val>
            <c:numRef>
              <c:f>Analyze!$U$139:$Z$139</c:f>
              <c:numCache>
                <c:formatCode>General</c:formatCode>
                <c:ptCount val="6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A06-F640-BC26-1B149E96D6AD}"/>
            </c:ext>
          </c:extLst>
        </c:ser>
        <c:ser>
          <c:idx val="1"/>
          <c:order val="1"/>
          <c:tx>
            <c:strRef>
              <c:f>Analyze!$T$140</c:f>
              <c:strCache>
                <c:ptCount val="1"/>
                <c:pt idx="0">
                  <c:v>A172-HRK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ze!$U$145:$AA$145</c:f>
                <c:numCache>
                  <c:formatCode>General</c:formatCode>
                  <c:ptCount val="7"/>
                  <c:pt idx="0">
                    <c:v>0.0371041573764128</c:v>
                  </c:pt>
                  <c:pt idx="1">
                    <c:v>0.00437788741111097</c:v>
                  </c:pt>
                  <c:pt idx="2">
                    <c:v>0.0586965107010474</c:v>
                  </c:pt>
                  <c:pt idx="3">
                    <c:v>0.0621551834499889</c:v>
                  </c:pt>
                  <c:pt idx="4">
                    <c:v>0.0248410544505698</c:v>
                  </c:pt>
                  <c:pt idx="5">
                    <c:v>0.261049854794607</c:v>
                  </c:pt>
                  <c:pt idx="6">
                    <c:v>0.146612677358098</c:v>
                  </c:pt>
                </c:numCache>
              </c:numRef>
            </c:plus>
            <c:minus>
              <c:numRef>
                <c:f>Analyze!$U$150:$AA$150</c:f>
                <c:numCache>
                  <c:formatCode>General</c:formatCode>
                  <c:ptCount val="7"/>
                  <c:pt idx="0">
                    <c:v>0.0357498185920463</c:v>
                  </c:pt>
                  <c:pt idx="1">
                    <c:v>0.00436040260933545</c:v>
                  </c:pt>
                  <c:pt idx="2">
                    <c:v>0.0545668105491016</c:v>
                  </c:pt>
                  <c:pt idx="3">
                    <c:v>0.0588508848698046</c:v>
                  </c:pt>
                  <c:pt idx="4">
                    <c:v>0.0244851961630241</c:v>
                  </c:pt>
                  <c:pt idx="5">
                    <c:v>0.208576976174669</c:v>
                  </c:pt>
                  <c:pt idx="6">
                    <c:v>0.13185963175367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ze!$U$138:$Z$138</c:f>
              <c:strCache>
                <c:ptCount val="6"/>
                <c:pt idx="0">
                  <c:v>Bad</c:v>
                </c:pt>
                <c:pt idx="1">
                  <c:v>Bak</c:v>
                </c:pt>
                <c:pt idx="2">
                  <c:v>Bim</c:v>
                </c:pt>
                <c:pt idx="3">
                  <c:v>Bik</c:v>
                </c:pt>
                <c:pt idx="4">
                  <c:v>Bcl-2</c:v>
                </c:pt>
                <c:pt idx="5">
                  <c:v>Bcl-xL</c:v>
                </c:pt>
              </c:strCache>
            </c:strRef>
          </c:cat>
          <c:val>
            <c:numRef>
              <c:f>Analyze!$U$140:$Z$140</c:f>
              <c:numCache>
                <c:formatCode>General</c:formatCode>
                <c:ptCount val="6"/>
                <c:pt idx="0">
                  <c:v>0.979420297586928</c:v>
                </c:pt>
                <c:pt idx="1">
                  <c:v>1.091768264570639</c:v>
                </c:pt>
                <c:pt idx="2">
                  <c:v>0.775572380916866</c:v>
                </c:pt>
                <c:pt idx="3">
                  <c:v>1.107008781595308</c:v>
                </c:pt>
                <c:pt idx="4">
                  <c:v>1.709214348529799</c:v>
                </c:pt>
                <c:pt idx="5">
                  <c:v>1.03765965915974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DA06-F640-BC26-1B149E96D6A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89164520"/>
        <c:axId val="-2089257048"/>
      </c:barChart>
      <c:catAx>
        <c:axId val="-2089164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89257048"/>
        <c:crosses val="autoZero"/>
        <c:auto val="1"/>
        <c:lblAlgn val="ctr"/>
        <c:lblOffset val="100"/>
        <c:noMultiLvlLbl val="0"/>
      </c:catAx>
      <c:valAx>
        <c:axId val="-2089257048"/>
        <c:scaling>
          <c:orientation val="minMax"/>
          <c:max val="2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891645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1837938534784"/>
          <c:y val="0.0537046895810512"/>
          <c:w val="0.673858534241477"/>
          <c:h val="0.113571448445269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nalyze!$C$104</c:f>
              <c:strCache>
                <c:ptCount val="1"/>
                <c:pt idx="0">
                  <c:v>0 ng/mL TRAIL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ze!$H$85:$H$88</c:f>
                <c:numCache>
                  <c:formatCode>General</c:formatCode>
                  <c:ptCount val="4"/>
                  <c:pt idx="0">
                    <c:v>1.213598970952396</c:v>
                  </c:pt>
                  <c:pt idx="1">
                    <c:v>0.564821270086636</c:v>
                  </c:pt>
                  <c:pt idx="2">
                    <c:v>0.915048288903776</c:v>
                  </c:pt>
                  <c:pt idx="3">
                    <c:v>0.558861320413124</c:v>
                  </c:pt>
                </c:numCache>
              </c:numRef>
            </c:plus>
            <c:minus>
              <c:numRef>
                <c:f>Analyze!$H$85:$H$88</c:f>
                <c:numCache>
                  <c:formatCode>General</c:formatCode>
                  <c:ptCount val="4"/>
                  <c:pt idx="0">
                    <c:v>1.213598970952396</c:v>
                  </c:pt>
                  <c:pt idx="1">
                    <c:v>0.564821270086636</c:v>
                  </c:pt>
                  <c:pt idx="2">
                    <c:v>0.915048288903776</c:v>
                  </c:pt>
                  <c:pt idx="3">
                    <c:v>0.5588613204131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Analyze!$B$105:$B$108</c:f>
              <c:strCache>
                <c:ptCount val="4"/>
                <c:pt idx="0">
                  <c:v>A172 - GFP</c:v>
                </c:pt>
                <c:pt idx="1">
                  <c:v>A172 - Bcl2</c:v>
                </c:pt>
                <c:pt idx="2">
                  <c:v>A172 - Bcl-xL</c:v>
                </c:pt>
                <c:pt idx="3">
                  <c:v>A172 - Bcl2+Bcl-xL</c:v>
                </c:pt>
              </c:strCache>
            </c:strRef>
          </c:cat>
          <c:val>
            <c:numRef>
              <c:f>Analyze!$C$105:$C$108</c:f>
              <c:numCache>
                <c:formatCode>0.00</c:formatCode>
                <c:ptCount val="4"/>
                <c:pt idx="0">
                  <c:v>100.0</c:v>
                </c:pt>
                <c:pt idx="1">
                  <c:v>100.0</c:v>
                </c:pt>
                <c:pt idx="2">
                  <c:v>100.0</c:v>
                </c:pt>
                <c:pt idx="3">
                  <c:v>10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2121-A745-A1AF-D8354BE2004A}"/>
            </c:ext>
          </c:extLst>
        </c:ser>
        <c:ser>
          <c:idx val="1"/>
          <c:order val="1"/>
          <c:tx>
            <c:strRef>
              <c:f>Analyze!$E$104</c:f>
              <c:strCache>
                <c:ptCount val="1"/>
                <c:pt idx="0">
                  <c:v>25 ng/mL TRAIL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ze!$J$85:$J$88</c:f>
                <c:numCache>
                  <c:formatCode>General</c:formatCode>
                  <c:ptCount val="4"/>
                  <c:pt idx="0">
                    <c:v>1.245171553230132</c:v>
                  </c:pt>
                  <c:pt idx="1">
                    <c:v>0.568446707141737</c:v>
                  </c:pt>
                  <c:pt idx="2">
                    <c:v>0.768284978850135</c:v>
                  </c:pt>
                  <c:pt idx="3">
                    <c:v>0.457490369600463</c:v>
                  </c:pt>
                </c:numCache>
              </c:numRef>
            </c:plus>
            <c:minus>
              <c:numRef>
                <c:f>Analyze!$J$85:$J$88</c:f>
                <c:numCache>
                  <c:formatCode>General</c:formatCode>
                  <c:ptCount val="4"/>
                  <c:pt idx="0">
                    <c:v>1.245171553230132</c:v>
                  </c:pt>
                  <c:pt idx="1">
                    <c:v>0.568446707141737</c:v>
                  </c:pt>
                  <c:pt idx="2">
                    <c:v>0.768284978850135</c:v>
                  </c:pt>
                  <c:pt idx="3">
                    <c:v>0.4574903696004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ze!$B$105:$B$108</c:f>
              <c:strCache>
                <c:ptCount val="4"/>
                <c:pt idx="0">
                  <c:v>A172 - GFP</c:v>
                </c:pt>
                <c:pt idx="1">
                  <c:v>A172 - Bcl2</c:v>
                </c:pt>
                <c:pt idx="2">
                  <c:v>A172 - Bcl-xL</c:v>
                </c:pt>
                <c:pt idx="3">
                  <c:v>A172 - Bcl2+Bcl-xL</c:v>
                </c:pt>
              </c:strCache>
            </c:strRef>
          </c:cat>
          <c:val>
            <c:numRef>
              <c:f>Analyze!$E$105:$E$108</c:f>
              <c:numCache>
                <c:formatCode>0.00</c:formatCode>
                <c:ptCount val="4"/>
                <c:pt idx="0">
                  <c:v>18.90938716005446</c:v>
                </c:pt>
                <c:pt idx="1">
                  <c:v>64.3465956945053</c:v>
                </c:pt>
                <c:pt idx="2">
                  <c:v>68.4635290503256</c:v>
                </c:pt>
                <c:pt idx="3">
                  <c:v>73.69435343996916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2121-A745-A1AF-D8354BE200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89783336"/>
        <c:axId val="-2089791464"/>
      </c:barChart>
      <c:catAx>
        <c:axId val="-20897833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89791464"/>
        <c:crosses val="autoZero"/>
        <c:auto val="1"/>
        <c:lblAlgn val="ctr"/>
        <c:lblOffset val="100"/>
        <c:noMultiLvlLbl val="0"/>
      </c:catAx>
      <c:valAx>
        <c:axId val="-20897914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noProof="0" dirty="0"/>
                  <a:t>% Cell Viabil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none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897833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[210516 CTG bcl2 bckxl.xlsx]Sheet1'!$C$20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chemeClr val="tx1"/>
            </a:solidFill>
            <a:ln w="12700"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210516 CTG bcl2 bckxl.xlsx]Sheet1'!$C$35:$C$38</c:f>
                <c:numCache>
                  <c:formatCode>General</c:formatCode>
                  <c:ptCount val="4"/>
                  <c:pt idx="0">
                    <c:v>1.740510037390651</c:v>
                  </c:pt>
                  <c:pt idx="1">
                    <c:v>0.997899676019825</c:v>
                  </c:pt>
                  <c:pt idx="2">
                    <c:v>0.491773310914332</c:v>
                  </c:pt>
                  <c:pt idx="3">
                    <c:v>0.0100839883800174</c:v>
                  </c:pt>
                </c:numCache>
              </c:numRef>
            </c:plus>
            <c:minus>
              <c:numRef>
                <c:f>'[210516 CTG bcl2 bckxl.xlsx]Sheet1'!$C$35:$C$38</c:f>
                <c:numCache>
                  <c:formatCode>General</c:formatCode>
                  <c:ptCount val="4"/>
                  <c:pt idx="0">
                    <c:v>1.740510037390651</c:v>
                  </c:pt>
                  <c:pt idx="1">
                    <c:v>0.997899676019825</c:v>
                  </c:pt>
                  <c:pt idx="2">
                    <c:v>0.491773310914332</c:v>
                  </c:pt>
                  <c:pt idx="3">
                    <c:v>0.01008398838001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210516 CTG bcl2 bckxl.xlsx]Sheet1'!$B$21:$B$24</c:f>
              <c:strCache>
                <c:ptCount val="4"/>
                <c:pt idx="0">
                  <c:v>U87MG-GFP</c:v>
                </c:pt>
                <c:pt idx="1">
                  <c:v>U87MG-Bcl-2</c:v>
                </c:pt>
                <c:pt idx="2">
                  <c:v>U87MG-Bcl-xL</c:v>
                </c:pt>
                <c:pt idx="3">
                  <c:v>U87MG-Bcl-2+Bcl-xL</c:v>
                </c:pt>
              </c:strCache>
            </c:strRef>
          </c:cat>
          <c:val>
            <c:numRef>
              <c:f>'[210516 CTG bcl2 bckxl.xlsx]Sheet1'!$C$21:$C$24</c:f>
              <c:numCache>
                <c:formatCode>General</c:formatCode>
                <c:ptCount val="4"/>
                <c:pt idx="0">
                  <c:v>100.0</c:v>
                </c:pt>
                <c:pt idx="1">
                  <c:v>100.0</c:v>
                </c:pt>
                <c:pt idx="2">
                  <c:v>100.0</c:v>
                </c:pt>
                <c:pt idx="3">
                  <c:v>100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E14A-9345-A792-A63072E982E7}"/>
            </c:ext>
          </c:extLst>
        </c:ser>
        <c:ser>
          <c:idx val="1"/>
          <c:order val="1"/>
          <c:tx>
            <c:strRef>
              <c:f>'[210516 CTG bcl2 bckxl.xlsx]Sheet1'!$F$20</c:f>
              <c:strCache>
                <c:ptCount val="1"/>
                <c:pt idx="0">
                  <c:v>250 ng/mL TRAIL</c:v>
                </c:pt>
              </c:strCache>
            </c:strRef>
          </c:tx>
          <c:spPr>
            <a:noFill/>
            <a:ln w="12700">
              <a:solidFill>
                <a:sysClr val="windowText" lastClr="000000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'[210516 CTG bcl2 bckxl.xlsx]Sheet1'!$F$35:$F$38</c:f>
                <c:numCache>
                  <c:formatCode>General</c:formatCode>
                  <c:ptCount val="4"/>
                  <c:pt idx="0">
                    <c:v>1.586669515205701</c:v>
                  </c:pt>
                  <c:pt idx="1">
                    <c:v>2.442509994649957</c:v>
                  </c:pt>
                  <c:pt idx="2">
                    <c:v>2.540392020924027</c:v>
                  </c:pt>
                  <c:pt idx="3">
                    <c:v>0.0178772459936671</c:v>
                  </c:pt>
                </c:numCache>
              </c:numRef>
            </c:plus>
            <c:minus>
              <c:numRef>
                <c:f>'[210516 CTG bcl2 bckxl.xlsx]Sheet1'!$F$35:$F$38</c:f>
                <c:numCache>
                  <c:formatCode>General</c:formatCode>
                  <c:ptCount val="4"/>
                  <c:pt idx="0">
                    <c:v>1.586669515205701</c:v>
                  </c:pt>
                  <c:pt idx="1">
                    <c:v>2.442509994649957</c:v>
                  </c:pt>
                  <c:pt idx="2">
                    <c:v>2.540392020924027</c:v>
                  </c:pt>
                  <c:pt idx="3">
                    <c:v>0.017877245993667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210516 CTG bcl2 bckxl.xlsx]Sheet1'!$B$21:$B$24</c:f>
              <c:strCache>
                <c:ptCount val="4"/>
                <c:pt idx="0">
                  <c:v>U87MG-GFP</c:v>
                </c:pt>
                <c:pt idx="1">
                  <c:v>U87MG-Bcl-2</c:v>
                </c:pt>
                <c:pt idx="2">
                  <c:v>U87MG-Bcl-xL</c:v>
                </c:pt>
                <c:pt idx="3">
                  <c:v>U87MG-Bcl-2+Bcl-xL</c:v>
                </c:pt>
              </c:strCache>
            </c:strRef>
          </c:cat>
          <c:val>
            <c:numRef>
              <c:f>'[210516 CTG bcl2 bckxl.xlsx]Sheet1'!$F$21:$F$24</c:f>
              <c:numCache>
                <c:formatCode>General</c:formatCode>
                <c:ptCount val="4"/>
                <c:pt idx="0">
                  <c:v>71.99243718614755</c:v>
                </c:pt>
                <c:pt idx="1">
                  <c:v>88.34746717374261</c:v>
                </c:pt>
                <c:pt idx="2">
                  <c:v>93.22049294495245</c:v>
                </c:pt>
                <c:pt idx="3">
                  <c:v>93.638041968267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E14A-9345-A792-A63072E982E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2117891000"/>
        <c:axId val="-2103223128"/>
      </c:barChart>
      <c:catAx>
        <c:axId val="211789100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03223128"/>
        <c:crosses val="autoZero"/>
        <c:auto val="1"/>
        <c:lblAlgn val="ctr"/>
        <c:lblOffset val="100"/>
        <c:noMultiLvlLbl val="0"/>
      </c:catAx>
      <c:valAx>
        <c:axId val="-210322312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noProof="0" dirty="0"/>
                  <a:t>% Cell Viability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21178910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800" b="1" i="0" u="none" strike="noStrike" kern="1200" baseline="0">
              <a:solidFill>
                <a:sysClr val="windowText" lastClr="000000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nalyze!$T$139</c:f>
              <c:strCache>
                <c:ptCount val="1"/>
                <c:pt idx="0">
                  <c:v>LN18-Control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ze!$U$144:$AA$144</c:f>
                <c:numCache>
                  <c:formatCode>General</c:formatCode>
                  <c:ptCount val="7"/>
                  <c:pt idx="0">
                    <c:v>0.0830022394501382</c:v>
                  </c:pt>
                  <c:pt idx="1">
                    <c:v>0.0631760351352698</c:v>
                  </c:pt>
                  <c:pt idx="2">
                    <c:v>0.0465629215281972</c:v>
                  </c:pt>
                  <c:pt idx="3">
                    <c:v>0.141202447159132</c:v>
                  </c:pt>
                  <c:pt idx="4">
                    <c:v>0.279550549749714</c:v>
                  </c:pt>
                  <c:pt idx="5">
                    <c:v>0.506994037530227</c:v>
                  </c:pt>
                  <c:pt idx="6">
                    <c:v>0.212906239688491</c:v>
                  </c:pt>
                </c:numCache>
              </c:numRef>
            </c:plus>
            <c:minus>
              <c:numRef>
                <c:f>Analyze!$U$149:$AA$149</c:f>
                <c:numCache>
                  <c:formatCode>General</c:formatCode>
                  <c:ptCount val="7"/>
                  <c:pt idx="0">
                    <c:v>0.0766408751770247</c:v>
                  </c:pt>
                  <c:pt idx="1">
                    <c:v>0.059421989442447</c:v>
                  </c:pt>
                  <c:pt idx="2">
                    <c:v>0.0444912776579221</c:v>
                  </c:pt>
                  <c:pt idx="3">
                    <c:v>0.12373128668856</c:v>
                  </c:pt>
                  <c:pt idx="4">
                    <c:v>0.218475580979897</c:v>
                  </c:pt>
                  <c:pt idx="5">
                    <c:v>0.336427367928493</c:v>
                  </c:pt>
                  <c:pt idx="6">
                    <c:v>0.17553396356768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ze!$U$138:$Z$138</c:f>
              <c:strCache>
                <c:ptCount val="6"/>
                <c:pt idx="0">
                  <c:v>Bad</c:v>
                </c:pt>
                <c:pt idx="1">
                  <c:v>Bak</c:v>
                </c:pt>
                <c:pt idx="2">
                  <c:v>Bim</c:v>
                </c:pt>
                <c:pt idx="3">
                  <c:v>Bik</c:v>
                </c:pt>
                <c:pt idx="4">
                  <c:v>Bcl-2</c:v>
                </c:pt>
                <c:pt idx="5">
                  <c:v>Bcl-xL</c:v>
                </c:pt>
              </c:strCache>
            </c:strRef>
          </c:cat>
          <c:val>
            <c:numRef>
              <c:f>Analyze!$U$139:$Z$139</c:f>
              <c:numCache>
                <c:formatCode>General</c:formatCode>
                <c:ptCount val="6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F65-C745-9485-04F7B38C3711}"/>
            </c:ext>
          </c:extLst>
        </c:ser>
        <c:ser>
          <c:idx val="1"/>
          <c:order val="1"/>
          <c:tx>
            <c:strRef>
              <c:f>Analyze!$T$140</c:f>
              <c:strCache>
                <c:ptCount val="1"/>
                <c:pt idx="0">
                  <c:v>LN18-HRK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ze!$U$145:$AA$145</c:f>
                <c:numCache>
                  <c:formatCode>General</c:formatCode>
                  <c:ptCount val="7"/>
                  <c:pt idx="0">
                    <c:v>0.0988593021313581</c:v>
                  </c:pt>
                  <c:pt idx="1">
                    <c:v>0.0169694867130793</c:v>
                  </c:pt>
                  <c:pt idx="2">
                    <c:v>0.119923941995245</c:v>
                  </c:pt>
                  <c:pt idx="3">
                    <c:v>0.0101092053066578</c:v>
                  </c:pt>
                  <c:pt idx="4">
                    <c:v>0.00486610428874192</c:v>
                  </c:pt>
                  <c:pt idx="5">
                    <c:v>0.16763238651872</c:v>
                  </c:pt>
                  <c:pt idx="6">
                    <c:v>0.0808039879676428</c:v>
                  </c:pt>
                </c:numCache>
              </c:numRef>
            </c:plus>
            <c:minus>
              <c:numRef>
                <c:f>Analyze!$U$150:$AA$150</c:f>
                <c:numCache>
                  <c:formatCode>General</c:formatCode>
                  <c:ptCount val="7"/>
                  <c:pt idx="0">
                    <c:v>0.0947898140258579</c:v>
                  </c:pt>
                  <c:pt idx="1">
                    <c:v>0.0168133778421146</c:v>
                  </c:pt>
                  <c:pt idx="2">
                    <c:v>0.112010279121972</c:v>
                  </c:pt>
                  <c:pt idx="3">
                    <c:v>0.00944284760921046</c:v>
                  </c:pt>
                  <c:pt idx="4">
                    <c:v>0.00481734275893832</c:v>
                  </c:pt>
                  <c:pt idx="5">
                    <c:v>0.135866278656983</c:v>
                  </c:pt>
                  <c:pt idx="6">
                    <c:v>0.071370297942222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ze!$U$138:$Z$138</c:f>
              <c:strCache>
                <c:ptCount val="6"/>
                <c:pt idx="0">
                  <c:v>Bad</c:v>
                </c:pt>
                <c:pt idx="1">
                  <c:v>Bak</c:v>
                </c:pt>
                <c:pt idx="2">
                  <c:v>Bim</c:v>
                </c:pt>
                <c:pt idx="3">
                  <c:v>Bik</c:v>
                </c:pt>
                <c:pt idx="4">
                  <c:v>Bcl-2</c:v>
                </c:pt>
                <c:pt idx="5">
                  <c:v>Bcl-xL</c:v>
                </c:pt>
              </c:strCache>
            </c:strRef>
          </c:cat>
          <c:val>
            <c:numRef>
              <c:f>Analyze!$U$140:$Z$140</c:f>
              <c:numCache>
                <c:formatCode>General</c:formatCode>
                <c:ptCount val="6"/>
                <c:pt idx="0">
                  <c:v>2.302710960399964</c:v>
                </c:pt>
                <c:pt idx="1">
                  <c:v>1.827662900458798</c:v>
                </c:pt>
                <c:pt idx="2">
                  <c:v>1.697407942618245</c:v>
                </c:pt>
                <c:pt idx="3">
                  <c:v>0.14325592024625</c:v>
                </c:pt>
                <c:pt idx="4">
                  <c:v>0.480741526241326</c:v>
                </c:pt>
                <c:pt idx="5">
                  <c:v>0.71697762400791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F65-C745-9485-04F7B38C371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115720968"/>
        <c:axId val="-2115717752"/>
      </c:barChart>
      <c:catAx>
        <c:axId val="-211572096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15717752"/>
        <c:crosses val="autoZero"/>
        <c:auto val="1"/>
        <c:lblAlgn val="ctr"/>
        <c:lblOffset val="100"/>
        <c:noMultiLvlLbl val="0"/>
      </c:catAx>
      <c:valAx>
        <c:axId val="-2115717752"/>
        <c:scaling>
          <c:orientation val="minMax"/>
          <c:max val="2.5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1572096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6695115038906"/>
          <c:y val="0.0828497884881257"/>
          <c:w val="0.76111514828105"/>
          <c:h val="0.0995313572034933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6727881497994"/>
          <c:y val="0.0377772406997713"/>
          <c:w val="0.825865035450641"/>
          <c:h val="0.61952443808213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nalyze!$T$160</c:f>
              <c:strCache>
                <c:ptCount val="1"/>
                <c:pt idx="0">
                  <c:v>U87MG-Control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ze!$U$165:$AA$165</c:f>
                <c:numCache>
                  <c:formatCode>General</c:formatCode>
                  <c:ptCount val="7"/>
                  <c:pt idx="0">
                    <c:v>0.0830022394501382</c:v>
                  </c:pt>
                  <c:pt idx="1">
                    <c:v>0.0669641735503187</c:v>
                  </c:pt>
                  <c:pt idx="2">
                    <c:v>0.173677719416823</c:v>
                  </c:pt>
                  <c:pt idx="3">
                    <c:v>0.122747049549163</c:v>
                  </c:pt>
                  <c:pt idx="4">
                    <c:v>0.407726547441265</c:v>
                  </c:pt>
                  <c:pt idx="5">
                    <c:v>0.0793980891436755</c:v>
                  </c:pt>
                  <c:pt idx="6">
                    <c:v>0.34948530897861</c:v>
                  </c:pt>
                </c:numCache>
              </c:numRef>
            </c:plus>
            <c:minus>
              <c:numRef>
                <c:f>Analyze!$U$170:$AA$170</c:f>
                <c:numCache>
                  <c:formatCode>General</c:formatCode>
                  <c:ptCount val="7"/>
                  <c:pt idx="0">
                    <c:v>0.0503031499026029</c:v>
                  </c:pt>
                  <c:pt idx="1">
                    <c:v>0.0627614077495169</c:v>
                  </c:pt>
                  <c:pt idx="2">
                    <c:v>0.147977350633458</c:v>
                  </c:pt>
                  <c:pt idx="3">
                    <c:v>0.109327430072921</c:v>
                  </c:pt>
                  <c:pt idx="4">
                    <c:v>0.289634764778971</c:v>
                  </c:pt>
                  <c:pt idx="5">
                    <c:v>0.073557744767424</c:v>
                  </c:pt>
                  <c:pt idx="6">
                    <c:v>0.2589767422093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ze!$U$138:$Z$138</c:f>
              <c:strCache>
                <c:ptCount val="6"/>
                <c:pt idx="0">
                  <c:v>Bad</c:v>
                </c:pt>
                <c:pt idx="1">
                  <c:v>Bak</c:v>
                </c:pt>
                <c:pt idx="2">
                  <c:v>Bim</c:v>
                </c:pt>
                <c:pt idx="3">
                  <c:v>Bik</c:v>
                </c:pt>
                <c:pt idx="4">
                  <c:v>Bcl-2</c:v>
                </c:pt>
                <c:pt idx="5">
                  <c:v>Bcl-xL</c:v>
                </c:pt>
              </c:strCache>
            </c:strRef>
          </c:cat>
          <c:val>
            <c:numRef>
              <c:f>Analyze!$U$160:$Z$160</c:f>
              <c:numCache>
                <c:formatCode>General</c:formatCode>
                <c:ptCount val="6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810-6544-9B9A-CAB030009636}"/>
            </c:ext>
          </c:extLst>
        </c:ser>
        <c:ser>
          <c:idx val="1"/>
          <c:order val="1"/>
          <c:tx>
            <c:strRef>
              <c:f>Analyze!$T$161</c:f>
              <c:strCache>
                <c:ptCount val="1"/>
                <c:pt idx="0">
                  <c:v>U87MG-HRK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ze!$U$166:$AA$166</c:f>
                <c:numCache>
                  <c:formatCode>General</c:formatCode>
                  <c:ptCount val="7"/>
                  <c:pt idx="0">
                    <c:v>0.0988593021313581</c:v>
                  </c:pt>
                  <c:pt idx="1">
                    <c:v>0.0379243701008224</c:v>
                  </c:pt>
                  <c:pt idx="2">
                    <c:v>0.118259322930778</c:v>
                  </c:pt>
                  <c:pt idx="3">
                    <c:v>0.0764490427724272</c:v>
                  </c:pt>
                  <c:pt idx="4">
                    <c:v>0.363300899240996</c:v>
                  </c:pt>
                  <c:pt idx="5">
                    <c:v>0.229680500910382</c:v>
                  </c:pt>
                  <c:pt idx="6">
                    <c:v>0.45493637397041</c:v>
                  </c:pt>
                </c:numCache>
              </c:numRef>
            </c:plus>
            <c:minus>
              <c:numRef>
                <c:f>Analyze!$U$171:$AA$171</c:f>
                <c:numCache>
                  <c:formatCode>General</c:formatCode>
                  <c:ptCount val="7"/>
                  <c:pt idx="0">
                    <c:v>0.0766956366618943</c:v>
                  </c:pt>
                  <c:pt idx="1">
                    <c:v>0.035929406756792</c:v>
                  </c:pt>
                  <c:pt idx="2">
                    <c:v>0.108695986547423</c:v>
                  </c:pt>
                  <c:pt idx="3">
                    <c:v>0.0685922072575107</c:v>
                  </c:pt>
                  <c:pt idx="4">
                    <c:v>0.274310884191002</c:v>
                  </c:pt>
                  <c:pt idx="5">
                    <c:v>0.178455187990354</c:v>
                  </c:pt>
                  <c:pt idx="6">
                    <c:v>0.3674097773224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ze!$U$138:$Z$138</c:f>
              <c:strCache>
                <c:ptCount val="6"/>
                <c:pt idx="0">
                  <c:v>Bad</c:v>
                </c:pt>
                <c:pt idx="1">
                  <c:v>Bak</c:v>
                </c:pt>
                <c:pt idx="2">
                  <c:v>Bim</c:v>
                </c:pt>
                <c:pt idx="3">
                  <c:v>Bik</c:v>
                </c:pt>
                <c:pt idx="4">
                  <c:v>Bcl-2</c:v>
                </c:pt>
                <c:pt idx="5">
                  <c:v>Bcl-xL</c:v>
                </c:pt>
              </c:strCache>
            </c:strRef>
          </c:cat>
          <c:val>
            <c:numRef>
              <c:f>Analyze!$U$161:$Z$161</c:f>
              <c:numCache>
                <c:formatCode>General</c:formatCode>
                <c:ptCount val="6"/>
                <c:pt idx="0">
                  <c:v>0.768437590644005</c:v>
                </c:pt>
                <c:pt idx="1">
                  <c:v>0.683020128377197</c:v>
                </c:pt>
                <c:pt idx="2">
                  <c:v>1.344124399593418</c:v>
                </c:pt>
                <c:pt idx="3">
                  <c:v>0.667419927085018</c:v>
                </c:pt>
                <c:pt idx="4">
                  <c:v>1.11987160404676</c:v>
                </c:pt>
                <c:pt idx="5">
                  <c:v>0.80014497972263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0810-6544-9B9A-CAB0300096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81216008"/>
        <c:axId val="-2081212616"/>
      </c:barChart>
      <c:catAx>
        <c:axId val="-20812160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81212616"/>
        <c:crosses val="autoZero"/>
        <c:auto val="1"/>
        <c:lblAlgn val="ctr"/>
        <c:lblOffset val="100"/>
        <c:noMultiLvlLbl val="0"/>
      </c:catAx>
      <c:valAx>
        <c:axId val="-2081212616"/>
        <c:scaling>
          <c:orientation val="minMax"/>
          <c:max val="2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812160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2114055766978"/>
          <c:y val="0.0207877075238432"/>
          <c:w val="0.728176956862121"/>
          <c:h val="0.118046027585153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aseline="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nalyze!$T$160</c:f>
              <c:strCache>
                <c:ptCount val="1"/>
                <c:pt idx="0">
                  <c:v>U373-Control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ze!$U$165:$AA$165</c:f>
                <c:numCache>
                  <c:formatCode>General</c:formatCode>
                  <c:ptCount val="7"/>
                  <c:pt idx="0">
                    <c:v>0.112554377878145</c:v>
                  </c:pt>
                  <c:pt idx="1">
                    <c:v>0.0230165793027008</c:v>
                  </c:pt>
                  <c:pt idx="2">
                    <c:v>0.0641421098006886</c:v>
                  </c:pt>
                  <c:pt idx="3">
                    <c:v>0.127961263077056</c:v>
                  </c:pt>
                  <c:pt idx="4">
                    <c:v>0.391951893215475</c:v>
                  </c:pt>
                  <c:pt idx="5">
                    <c:v>0.0642334272072696</c:v>
                  </c:pt>
                  <c:pt idx="6">
                    <c:v>0.361793968599727</c:v>
                  </c:pt>
                </c:numCache>
              </c:numRef>
            </c:plus>
            <c:minus>
              <c:numRef>
                <c:f>Analyze!$U$170:$AA$170</c:f>
                <c:numCache>
                  <c:formatCode>General</c:formatCode>
                  <c:ptCount val="7"/>
                  <c:pt idx="0">
                    <c:v>0.00609433726934431</c:v>
                  </c:pt>
                  <c:pt idx="1">
                    <c:v>0.0224987353757153</c:v>
                  </c:pt>
                  <c:pt idx="2">
                    <c:v>0.060275887224032</c:v>
                  </c:pt>
                  <c:pt idx="3">
                    <c:v>0.113444731894409</c:v>
                  </c:pt>
                  <c:pt idx="4">
                    <c:v>0.281584367337616</c:v>
                  </c:pt>
                  <c:pt idx="5">
                    <c:v>0.0603565210085811</c:v>
                  </c:pt>
                  <c:pt idx="6">
                    <c:v>0.2656745270885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ze!$U$138:$Z$138</c:f>
              <c:strCache>
                <c:ptCount val="6"/>
                <c:pt idx="0">
                  <c:v>Bad</c:v>
                </c:pt>
                <c:pt idx="1">
                  <c:v>Bak</c:v>
                </c:pt>
                <c:pt idx="2">
                  <c:v>Bim</c:v>
                </c:pt>
                <c:pt idx="3">
                  <c:v>Bik</c:v>
                </c:pt>
                <c:pt idx="4">
                  <c:v>Bcl-2</c:v>
                </c:pt>
                <c:pt idx="5">
                  <c:v>Bcl-xL</c:v>
                </c:pt>
              </c:strCache>
            </c:strRef>
          </c:cat>
          <c:val>
            <c:numRef>
              <c:f>Analyze!$U$160:$Z$160</c:f>
              <c:numCache>
                <c:formatCode>General</c:formatCode>
                <c:ptCount val="6"/>
                <c:pt idx="0">
                  <c:v>1.0</c:v>
                </c:pt>
                <c:pt idx="1">
                  <c:v>1.0</c:v>
                </c:pt>
                <c:pt idx="2">
                  <c:v>1.0</c:v>
                </c:pt>
                <c:pt idx="3">
                  <c:v>1.0</c:v>
                </c:pt>
                <c:pt idx="4">
                  <c:v>1.0</c:v>
                </c:pt>
                <c:pt idx="5">
                  <c:v>1.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45F-3840-87D5-99527076F19A}"/>
            </c:ext>
          </c:extLst>
        </c:ser>
        <c:ser>
          <c:idx val="1"/>
          <c:order val="1"/>
          <c:tx>
            <c:strRef>
              <c:f>Analyze!$T$161</c:f>
              <c:strCache>
                <c:ptCount val="1"/>
                <c:pt idx="0">
                  <c:v>U373-HRK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nalyze!$U$166:$AA$166</c:f>
                <c:numCache>
                  <c:formatCode>General</c:formatCode>
                  <c:ptCount val="7"/>
                  <c:pt idx="0">
                    <c:v>0.0371041573764128</c:v>
                  </c:pt>
                  <c:pt idx="1">
                    <c:v>0.0275970709991325</c:v>
                  </c:pt>
                  <c:pt idx="2">
                    <c:v>0.0623093390763276</c:v>
                  </c:pt>
                  <c:pt idx="3">
                    <c:v>0.0788485339231718</c:v>
                  </c:pt>
                  <c:pt idx="4">
                    <c:v>0.433611878116898</c:v>
                  </c:pt>
                  <c:pt idx="5">
                    <c:v>0.261411353321995</c:v>
                  </c:pt>
                  <c:pt idx="6">
                    <c:v>0.526210172285903</c:v>
                  </c:pt>
                </c:numCache>
              </c:numRef>
            </c:plus>
            <c:minus>
              <c:numRef>
                <c:f>Analyze!$U$171:$AA$171</c:f>
                <c:numCache>
                  <c:formatCode>General</c:formatCode>
                  <c:ptCount val="7"/>
                  <c:pt idx="0">
                    <c:v>0.0473008502170804</c:v>
                  </c:pt>
                  <c:pt idx="1">
                    <c:v>0.0268095798198457</c:v>
                  </c:pt>
                  <c:pt idx="2">
                    <c:v>0.0587797362035606</c:v>
                  </c:pt>
                  <c:pt idx="3">
                    <c:v>0.0717830023687817</c:v>
                  </c:pt>
                  <c:pt idx="4">
                    <c:v>0.32784857497599</c:v>
                  </c:pt>
                  <c:pt idx="5">
                    <c:v>0.205225758673053</c:v>
                  </c:pt>
                  <c:pt idx="6">
                    <c:v>0.42796063733034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nalyze!$U$138:$Z$138</c:f>
              <c:strCache>
                <c:ptCount val="6"/>
                <c:pt idx="0">
                  <c:v>Bad</c:v>
                </c:pt>
                <c:pt idx="1">
                  <c:v>Bak</c:v>
                </c:pt>
                <c:pt idx="2">
                  <c:v>Bim</c:v>
                </c:pt>
                <c:pt idx="3">
                  <c:v>Bik</c:v>
                </c:pt>
                <c:pt idx="4">
                  <c:v>Bcl-2</c:v>
                </c:pt>
                <c:pt idx="5">
                  <c:v>Bcl-xL</c:v>
                </c:pt>
              </c:strCache>
            </c:strRef>
          </c:cat>
          <c:val>
            <c:numRef>
              <c:f>Analyze!$U$161:$Z$161</c:f>
              <c:numCache>
                <c:formatCode>General</c:formatCode>
                <c:ptCount val="6"/>
                <c:pt idx="0">
                  <c:v>1.262835451191641</c:v>
                </c:pt>
                <c:pt idx="1">
                  <c:v>0.939522749214012</c:v>
                </c:pt>
                <c:pt idx="2">
                  <c:v>1.037659659159746</c:v>
                </c:pt>
                <c:pt idx="3">
                  <c:v>0.801069877589622</c:v>
                </c:pt>
                <c:pt idx="4">
                  <c:v>1.344124399593415</c:v>
                </c:pt>
                <c:pt idx="5">
                  <c:v>0.95484160391041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145F-3840-87D5-99527076F19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2081276120"/>
        <c:axId val="-2081271528"/>
      </c:barChart>
      <c:catAx>
        <c:axId val="-20812761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81271528"/>
        <c:crosses val="autoZero"/>
        <c:auto val="1"/>
        <c:lblAlgn val="ctr"/>
        <c:lblOffset val="100"/>
        <c:noMultiLvlLbl val="0"/>
      </c:catAx>
      <c:valAx>
        <c:axId val="-2081271528"/>
        <c:scaling>
          <c:orientation val="minMax"/>
          <c:max val="2.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12700"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0812761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152835194501441"/>
          <c:y val="0.0154244988288308"/>
          <c:w val="0.656956316460781"/>
          <c:h val="0.113001024294364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ysClr val="windowText" lastClr="000000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rgbClr val="C00000"/>
              </a:solidFill>
              <a:ln w="9525">
                <a:solidFill>
                  <a:sysClr val="windowText" lastClr="000000"/>
                </a:solidFill>
              </a:ln>
              <a:effectLst/>
            </c:spPr>
          </c:marker>
          <c:trendline>
            <c:spPr>
              <a:ln w="28575" cap="rnd">
                <a:solidFill>
                  <a:sysClr val="windowText" lastClr="000000"/>
                </a:solidFill>
                <a:prstDash val="sysDot"/>
              </a:ln>
              <a:effectLst/>
            </c:spPr>
            <c:trendlineType val="exp"/>
            <c:dispRSqr val="1"/>
            <c:dispEq val="0"/>
            <c:trendlineLbl>
              <c:layout/>
              <c:numFmt formatCode="General" sourceLinked="0"/>
              <c:spPr>
                <a:noFill/>
                <a:ln>
                  <a:noFill/>
                </a:ln>
                <a:effectLst/>
              </c:spPr>
              <c:txPr>
                <a:bodyPr rot="0" spcFirstLastPara="1" vertOverflow="ellipsis" vert="horz" wrap="square" anchor="ctr" anchorCtr="1"/>
                <a:lstStyle/>
                <a:p>
                  <a:pPr>
                    <a:defRPr sz="800" b="1" i="0" u="none" strike="noStrike" kern="1200" baseline="0">
                      <a:solidFill>
                        <a:sysClr val="windowText" lastClr="000000"/>
                      </a:solidFill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defRPr>
                  </a:pPr>
                  <a:endParaRPr lang="en-US"/>
                </a:p>
              </c:txPr>
            </c:trendlineLbl>
          </c:trendline>
          <c:cat>
            <c:numRef>
              <c:f>'Plate 1 - Sheet1'!$A$39:$G$39</c:f>
              <c:numCache>
                <c:formatCode>General</c:formatCode>
                <c:ptCount val="7"/>
                <c:pt idx="0">
                  <c:v>0.0</c:v>
                </c:pt>
                <c:pt idx="1">
                  <c:v>390.625</c:v>
                </c:pt>
                <c:pt idx="2">
                  <c:v>781.25</c:v>
                </c:pt>
                <c:pt idx="3">
                  <c:v>1562.5</c:v>
                </c:pt>
                <c:pt idx="4">
                  <c:v>3125.0</c:v>
                </c:pt>
                <c:pt idx="5">
                  <c:v>6250.0</c:v>
                </c:pt>
                <c:pt idx="6">
                  <c:v>12500.0</c:v>
                </c:pt>
              </c:numCache>
            </c:numRef>
          </c:cat>
          <c:val>
            <c:numRef>
              <c:f>'Plate 1 - Sheet1'!$A$40:$G$40</c:f>
              <c:numCache>
                <c:formatCode>General</c:formatCode>
                <c:ptCount val="7"/>
                <c:pt idx="0">
                  <c:v>4.75</c:v>
                </c:pt>
                <c:pt idx="1">
                  <c:v>17.5</c:v>
                </c:pt>
                <c:pt idx="2">
                  <c:v>29.0</c:v>
                </c:pt>
                <c:pt idx="3">
                  <c:v>51.75</c:v>
                </c:pt>
                <c:pt idx="4">
                  <c:v>104.0</c:v>
                </c:pt>
                <c:pt idx="5">
                  <c:v>172.0</c:v>
                </c:pt>
                <c:pt idx="6">
                  <c:v>260.75</c:v>
                </c:pt>
              </c:numCache>
            </c:numRef>
          </c: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69E-724D-8F62-C632FC57106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080433256"/>
        <c:axId val="-2100148168"/>
      </c:lineChart>
      <c:catAx>
        <c:axId val="-2080433256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tr-TR"/>
                  <a:t>Cell Number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100148168"/>
        <c:crosses val="autoZero"/>
        <c:auto val="1"/>
        <c:lblAlgn val="ctr"/>
        <c:lblOffset val="100"/>
        <c:noMultiLvlLbl val="0"/>
      </c:catAx>
      <c:valAx>
        <c:axId val="-21001481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8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tr-TR"/>
                  <a:t>Relative Luminscence Unit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12700">
            <a:solidFill>
              <a:sysClr val="windowText" lastClr="000000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2080433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800" b="1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HRK expression in A172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A172'!$V$4:$V$15</c:f>
                <c:numCache>
                  <c:formatCode>General</c:formatCode>
                  <c:ptCount val="12"/>
                  <c:pt idx="0">
                    <c:v>0.214194884395045</c:v>
                  </c:pt>
                  <c:pt idx="1">
                    <c:v>0.472411738528362</c:v>
                  </c:pt>
                  <c:pt idx="2">
                    <c:v>1.814879640016166</c:v>
                  </c:pt>
                </c:numCache>
              </c:numRef>
            </c:plus>
            <c:minus>
              <c:numRef>
                <c:f>'A172'!$W$4:$W$15</c:f>
                <c:numCache>
                  <c:formatCode>General</c:formatCode>
                  <c:ptCount val="12"/>
                  <c:pt idx="0">
                    <c:v>0.176408982732427</c:v>
                  </c:pt>
                  <c:pt idx="1">
                    <c:v>0.422820349783553</c:v>
                  </c:pt>
                  <c:pt idx="2">
                    <c:v>1.72892330695569</c:v>
                  </c:pt>
                </c:numCache>
              </c:numRef>
            </c:minus>
          </c:errBars>
          <c:cat>
            <c:strRef>
              <c:f>'A172'!$T$4:$T$6</c:f>
              <c:strCache>
                <c:ptCount val="3"/>
                <c:pt idx="0">
                  <c:v>5-aza (0 uM)</c:v>
                </c:pt>
                <c:pt idx="1">
                  <c:v>5-aza (2.5 uM)</c:v>
                </c:pt>
                <c:pt idx="2">
                  <c:v>5-aza (10 uM)</c:v>
                </c:pt>
              </c:strCache>
            </c:strRef>
          </c:cat>
          <c:val>
            <c:numRef>
              <c:f>'A172'!$U$4:$U$6</c:f>
              <c:numCache>
                <c:formatCode>General</c:formatCode>
                <c:ptCount val="3"/>
                <c:pt idx="0">
                  <c:v>1.0</c:v>
                </c:pt>
                <c:pt idx="1">
                  <c:v>4.027822200226868</c:v>
                </c:pt>
                <c:pt idx="2">
                  <c:v>36.5044389077895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A272-2145-8010-873CC2A55CF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5372984"/>
        <c:axId val="-2085369720"/>
      </c:barChart>
      <c:catAx>
        <c:axId val="-208537298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85369720"/>
        <c:crosses val="autoZero"/>
        <c:auto val="1"/>
        <c:lblAlgn val="ctr"/>
        <c:lblOffset val="100"/>
        <c:noMultiLvlLbl val="0"/>
      </c:catAx>
      <c:valAx>
        <c:axId val="-2085369720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0.0312985565393774"/>
              <c:y val="0.178054942295394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8537298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HRK expression in LN18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LN18'!$V$4:$V$15</c:f>
                <c:numCache>
                  <c:formatCode>General</c:formatCode>
                  <c:ptCount val="12"/>
                  <c:pt idx="0">
                    <c:v>0.160703914383718</c:v>
                  </c:pt>
                  <c:pt idx="1">
                    <c:v>0.405407282133975</c:v>
                  </c:pt>
                  <c:pt idx="2">
                    <c:v>3.63118183455421</c:v>
                  </c:pt>
                </c:numCache>
              </c:numRef>
            </c:plus>
            <c:minus>
              <c:numRef>
                <c:f>'LN18'!$W$4:$W$15</c:f>
                <c:numCache>
                  <c:formatCode>General</c:formatCode>
                  <c:ptCount val="12"/>
                  <c:pt idx="0">
                    <c:v>0.138453840287983</c:v>
                  </c:pt>
                  <c:pt idx="1">
                    <c:v>0.388892659464295</c:v>
                  </c:pt>
                  <c:pt idx="2">
                    <c:v>3.47121127207348</c:v>
                  </c:pt>
                </c:numCache>
              </c:numRef>
            </c:minus>
          </c:errBars>
          <c:cat>
            <c:strRef>
              <c:f>'LN18'!$T$4:$T$6</c:f>
              <c:strCache>
                <c:ptCount val="3"/>
                <c:pt idx="0">
                  <c:v>5-aza (0 uM)</c:v>
                </c:pt>
                <c:pt idx="1">
                  <c:v>5-aza (2.5 uM)</c:v>
                </c:pt>
                <c:pt idx="2">
                  <c:v>5-aza (10 uM)</c:v>
                </c:pt>
              </c:strCache>
            </c:strRef>
          </c:cat>
          <c:val>
            <c:numRef>
              <c:f>'LN18'!$U$4:$U$6</c:f>
              <c:numCache>
                <c:formatCode>General</c:formatCode>
                <c:ptCount val="3"/>
                <c:pt idx="0">
                  <c:v>1.0</c:v>
                </c:pt>
                <c:pt idx="1">
                  <c:v>9.546685944253768</c:v>
                </c:pt>
                <c:pt idx="2">
                  <c:v>78.7932424540744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DF2E-A644-AC8B-53AA12EE9D4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5435752"/>
        <c:axId val="-2085439976"/>
      </c:barChart>
      <c:catAx>
        <c:axId val="-2085435752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85439976"/>
        <c:crosses val="autoZero"/>
        <c:auto val="1"/>
        <c:lblAlgn val="ctr"/>
        <c:lblOffset val="100"/>
        <c:noMultiLvlLbl val="0"/>
      </c:catAx>
      <c:valAx>
        <c:axId val="-20854399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0.0277551236783623"/>
              <c:y val="0.224697911028537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85435752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HRK expression in U87MG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U87'!$V$4:$V$15</c:f>
                <c:numCache>
                  <c:formatCode>General</c:formatCode>
                  <c:ptCount val="12"/>
                  <c:pt idx="0">
                    <c:v>0.0174796921026875</c:v>
                  </c:pt>
                  <c:pt idx="1">
                    <c:v>0.305952097315819</c:v>
                  </c:pt>
                  <c:pt idx="2">
                    <c:v>0.119895252312423</c:v>
                  </c:pt>
                </c:numCache>
              </c:numRef>
            </c:plus>
            <c:minus>
              <c:numRef>
                <c:f>'U87'!$W$4:$W$15</c:f>
                <c:numCache>
                  <c:formatCode>General</c:formatCode>
                  <c:ptCount val="12"/>
                  <c:pt idx="0">
                    <c:v>0.0171794014547483</c:v>
                  </c:pt>
                  <c:pt idx="1">
                    <c:v>0.267271459663971</c:v>
                  </c:pt>
                  <c:pt idx="2">
                    <c:v>0.118655134523559</c:v>
                  </c:pt>
                </c:numCache>
              </c:numRef>
            </c:minus>
          </c:errBars>
          <c:cat>
            <c:strRef>
              <c:f>'U87'!$T$4:$T$6</c:f>
              <c:strCache>
                <c:ptCount val="3"/>
                <c:pt idx="0">
                  <c:v>5-aza (0 uM)</c:v>
                </c:pt>
                <c:pt idx="1">
                  <c:v>5-aza (2.5 uM)</c:v>
                </c:pt>
                <c:pt idx="2">
                  <c:v>5-aza (10 uM)</c:v>
                </c:pt>
              </c:strCache>
            </c:strRef>
          </c:cat>
          <c:val>
            <c:numRef>
              <c:f>'U87'!$U$4:$U$6</c:f>
              <c:numCache>
                <c:formatCode>General</c:formatCode>
                <c:ptCount val="3"/>
                <c:pt idx="0">
                  <c:v>1.0</c:v>
                </c:pt>
                <c:pt idx="1">
                  <c:v>2.114036081122765</c:v>
                </c:pt>
                <c:pt idx="2">
                  <c:v>11.471641984126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8FC-C44A-98BD-041B6EDAAA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4137624"/>
        <c:axId val="-2133665832"/>
      </c:barChart>
      <c:catAx>
        <c:axId val="-208413762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33665832"/>
        <c:crosses val="autoZero"/>
        <c:auto val="1"/>
        <c:lblAlgn val="ctr"/>
        <c:lblOffset val="100"/>
        <c:noMultiLvlLbl val="0"/>
      </c:catAx>
      <c:valAx>
        <c:axId val="-213366583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0.0277551236783623"/>
              <c:y val="0.18971568447868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8413762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HRK expression in U373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'U373'!$V$4:$V$15</c:f>
                <c:numCache>
                  <c:formatCode>General</c:formatCode>
                  <c:ptCount val="12"/>
                  <c:pt idx="0">
                    <c:v>0.319507910772897</c:v>
                  </c:pt>
                  <c:pt idx="1">
                    <c:v>0.243026386330725</c:v>
                  </c:pt>
                  <c:pt idx="2">
                    <c:v>4.556854311118045</c:v>
                  </c:pt>
                </c:numCache>
              </c:numRef>
            </c:plus>
            <c:minus>
              <c:numRef>
                <c:f>'U373'!$W$4:$W$15</c:f>
                <c:numCache>
                  <c:formatCode>General</c:formatCode>
                  <c:ptCount val="12"/>
                  <c:pt idx="0">
                    <c:v>0.242141716744801</c:v>
                  </c:pt>
                  <c:pt idx="1">
                    <c:v>0.222856178870695</c:v>
                  </c:pt>
                  <c:pt idx="2">
                    <c:v>3.831842455052576</c:v>
                  </c:pt>
                </c:numCache>
              </c:numRef>
            </c:minus>
          </c:errBars>
          <c:cat>
            <c:strRef>
              <c:f>'U373'!$T$4:$T$6</c:f>
              <c:strCache>
                <c:ptCount val="3"/>
                <c:pt idx="0">
                  <c:v>5-aza (0 uM)</c:v>
                </c:pt>
                <c:pt idx="1">
                  <c:v>5-aza (2.5 uM)</c:v>
                </c:pt>
                <c:pt idx="2">
                  <c:v>5-aza (10 uM)</c:v>
                </c:pt>
              </c:strCache>
            </c:strRef>
          </c:cat>
          <c:val>
            <c:numRef>
              <c:f>'U373'!$U$4:$U$6</c:f>
              <c:numCache>
                <c:formatCode>General</c:formatCode>
                <c:ptCount val="3"/>
                <c:pt idx="0">
                  <c:v>1.0</c:v>
                </c:pt>
                <c:pt idx="1">
                  <c:v>2.68514500556053</c:v>
                </c:pt>
                <c:pt idx="2">
                  <c:v>24.0839479585770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E23-7642-B31F-3C03987EA2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085536888"/>
        <c:axId val="-2085533624"/>
      </c:barChart>
      <c:catAx>
        <c:axId val="-208553688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85533624"/>
        <c:crosses val="autoZero"/>
        <c:auto val="1"/>
        <c:lblAlgn val="ctr"/>
        <c:lblOffset val="100"/>
        <c:noMultiLvlLbl val="0"/>
      </c:catAx>
      <c:valAx>
        <c:axId val="-20855336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Relative Fold Change</a:t>
                </a:r>
              </a:p>
            </c:rich>
          </c:tx>
          <c:layout>
            <c:manualLayout>
              <c:xMode val="edge"/>
              <c:yMode val="edge"/>
              <c:x val="0.0348419894003926"/>
              <c:y val="0.248019395395109"/>
            </c:manualLayout>
          </c:layout>
          <c:overlay val="0"/>
        </c:title>
        <c:numFmt formatCode="General" sourceLinked="1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085536888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800">
          <a:latin typeface="Arial"/>
          <a:cs typeface="Arial"/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Horizont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Shape 8"/>
          <p:cNvSpPr>
            <a:spLocks noGrp="1"/>
          </p:cNvSpPr>
          <p:nvPr>
            <p:ph type="title"/>
          </p:nvPr>
        </p:nvSpPr>
        <p:spPr>
          <a:xfrm>
            <a:off x="892969" y="4723805"/>
            <a:ext cx="7358063" cy="1000125"/>
          </a:xfrm>
          <a:prstGeom prst="rect">
            <a:avLst/>
          </a:prstGeom>
        </p:spPr>
        <p:txBody>
          <a:bodyPr anchor="b"/>
          <a:lstStyle/>
          <a:p>
            <a:pPr lvl="0">
              <a:defRPr sz="1800"/>
            </a:pPr>
            <a:r>
              <a:rPr lang="en-US" sz="5600"/>
              <a:t>Click to edit Master title style</a:t>
            </a:r>
            <a:endParaRPr sz="5600"/>
          </a:p>
        </p:txBody>
      </p:sp>
      <p:sp>
        <p:nvSpPr>
          <p:cNvPr id="9" name="Shape 9"/>
          <p:cNvSpPr>
            <a:spLocks noGrp="1"/>
          </p:cNvSpPr>
          <p:nvPr>
            <p:ph type="body" idx="1"/>
          </p:nvPr>
        </p:nvSpPr>
        <p:spPr>
          <a:xfrm>
            <a:off x="892969" y="5759649"/>
            <a:ext cx="7358063" cy="794742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2200"/>
            </a:lvl1pPr>
            <a:lvl2pPr marL="0" indent="160729" algn="ctr">
              <a:spcBef>
                <a:spcPts val="0"/>
              </a:spcBef>
              <a:buSzTx/>
              <a:buNone/>
              <a:defRPr sz="2200"/>
            </a:lvl2pPr>
            <a:lvl3pPr marL="0" indent="321457" algn="ctr">
              <a:spcBef>
                <a:spcPts val="0"/>
              </a:spcBef>
              <a:buSzTx/>
              <a:buNone/>
              <a:defRPr sz="2200"/>
            </a:lvl3pPr>
            <a:lvl4pPr marL="0" indent="482186" algn="ctr">
              <a:spcBef>
                <a:spcPts val="0"/>
              </a:spcBef>
              <a:buSzTx/>
              <a:buNone/>
              <a:defRPr sz="2200"/>
            </a:lvl4pPr>
            <a:lvl5pPr marL="0" indent="642915" algn="ctr">
              <a:spcBef>
                <a:spcPts val="0"/>
              </a:spcBef>
              <a:buSzTx/>
              <a:buNone/>
              <a:defRPr sz="2200"/>
            </a:lvl5pPr>
          </a:lstStyle>
          <a:p>
            <a:pPr lvl="0">
              <a:defRPr sz="1800"/>
            </a:pPr>
            <a:r>
              <a:rPr lang="en-US" sz="2200"/>
              <a:t>Edit Master text styles</a:t>
            </a:r>
          </a:p>
          <a:p>
            <a:pPr lvl="1">
              <a:defRPr sz="1800"/>
            </a:pPr>
            <a:r>
              <a:rPr lang="en-US" sz="2200"/>
              <a:t>Second level</a:t>
            </a:r>
          </a:p>
          <a:p>
            <a:pPr lvl="2">
              <a:defRPr sz="1800"/>
            </a:pPr>
            <a:r>
              <a:rPr lang="en-US" sz="2200"/>
              <a:t>Third level</a:t>
            </a:r>
          </a:p>
          <a:p>
            <a:pPr lvl="3">
              <a:defRPr sz="1800"/>
            </a:pPr>
            <a:r>
              <a:rPr lang="en-US" sz="2200"/>
              <a:t>Fourth level</a:t>
            </a:r>
          </a:p>
          <a:p>
            <a:pPr lvl="4">
              <a:defRPr sz="1800"/>
            </a:pPr>
            <a:r>
              <a:rPr lang="en-US" sz="2200"/>
              <a:t>Fifth level</a:t>
            </a:r>
            <a:endParaRPr sz="2200"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xmlns:p14="http://schemas.microsoft.com/office/powerpoint/2010/main" spd="med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xmlns:p14="http://schemas.microsoft.com/office/powerpoint/2010/main" spd="med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Cent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Shape 11"/>
          <p:cNvSpPr>
            <a:spLocks noGrp="1"/>
          </p:cNvSpPr>
          <p:nvPr>
            <p:ph type="title"/>
          </p:nvPr>
        </p:nvSpPr>
        <p:spPr>
          <a:xfrm>
            <a:off x="892969" y="2268141"/>
            <a:ext cx="7358063" cy="2321719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lang="en-US" sz="5600"/>
              <a:t>Click to edit Master title style</a:t>
            </a:r>
            <a:endParaRPr sz="5600"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Shape 13"/>
          <p:cNvSpPr>
            <a:spLocks noGrp="1"/>
          </p:cNvSpPr>
          <p:nvPr>
            <p:ph type="title"/>
          </p:nvPr>
        </p:nvSpPr>
        <p:spPr>
          <a:xfrm>
            <a:off x="669726" y="446484"/>
            <a:ext cx="3750469" cy="2803922"/>
          </a:xfrm>
          <a:prstGeom prst="rect">
            <a:avLst/>
          </a:prstGeom>
        </p:spPr>
        <p:txBody>
          <a:bodyPr anchor="b"/>
          <a:lstStyle>
            <a:lvl1pPr>
              <a:defRPr sz="4200"/>
            </a:lvl1pPr>
          </a:lstStyle>
          <a:p>
            <a:pPr lvl="0">
              <a:defRPr sz="1800"/>
            </a:pPr>
            <a:r>
              <a:rPr lang="en-US" sz="4200"/>
              <a:t>Click to edit Master title style</a:t>
            </a:r>
            <a:endParaRPr sz="4200"/>
          </a:p>
        </p:txBody>
      </p:sp>
      <p:sp>
        <p:nvSpPr>
          <p:cNvPr id="14" name="Shape 14"/>
          <p:cNvSpPr>
            <a:spLocks noGrp="1"/>
          </p:cNvSpPr>
          <p:nvPr>
            <p:ph type="body" idx="1"/>
          </p:nvPr>
        </p:nvSpPr>
        <p:spPr>
          <a:xfrm>
            <a:off x="669726" y="3348633"/>
            <a:ext cx="3750469" cy="2884289"/>
          </a:xfrm>
          <a:prstGeom prst="rect">
            <a:avLst/>
          </a:prstGeom>
        </p:spPr>
        <p:txBody>
          <a:bodyPr anchor="t"/>
          <a:lstStyle>
            <a:lvl1pPr marL="0" indent="0" algn="ctr">
              <a:spcBef>
                <a:spcPts val="0"/>
              </a:spcBef>
              <a:buSzTx/>
              <a:buNone/>
              <a:defRPr sz="2200"/>
            </a:lvl1pPr>
            <a:lvl2pPr marL="0" indent="160729" algn="ctr">
              <a:spcBef>
                <a:spcPts val="0"/>
              </a:spcBef>
              <a:buSzTx/>
              <a:buNone/>
              <a:defRPr sz="2200"/>
            </a:lvl2pPr>
            <a:lvl3pPr marL="0" indent="321457" algn="ctr">
              <a:spcBef>
                <a:spcPts val="0"/>
              </a:spcBef>
              <a:buSzTx/>
              <a:buNone/>
              <a:defRPr sz="2200"/>
            </a:lvl3pPr>
            <a:lvl4pPr marL="0" indent="482186" algn="ctr">
              <a:spcBef>
                <a:spcPts val="0"/>
              </a:spcBef>
              <a:buSzTx/>
              <a:buNone/>
              <a:defRPr sz="2200"/>
            </a:lvl4pPr>
            <a:lvl5pPr marL="0" indent="642915" algn="ctr">
              <a:spcBef>
                <a:spcPts val="0"/>
              </a:spcBef>
              <a:buSzTx/>
              <a:buNone/>
              <a:defRPr sz="2200"/>
            </a:lvl5pPr>
          </a:lstStyle>
          <a:p>
            <a:pPr lvl="0">
              <a:defRPr sz="1800"/>
            </a:pPr>
            <a:r>
              <a:rPr lang="en-US" sz="2200"/>
              <a:t>Edit Master text styles</a:t>
            </a:r>
          </a:p>
          <a:p>
            <a:pPr lvl="1">
              <a:defRPr sz="1800"/>
            </a:pPr>
            <a:r>
              <a:rPr lang="en-US" sz="2200"/>
              <a:t>Second level</a:t>
            </a:r>
          </a:p>
          <a:p>
            <a:pPr lvl="2">
              <a:defRPr sz="1800"/>
            </a:pPr>
            <a:r>
              <a:rPr lang="en-US" sz="2200"/>
              <a:t>Third level</a:t>
            </a:r>
          </a:p>
          <a:p>
            <a:pPr lvl="3">
              <a:defRPr sz="1800"/>
            </a:pPr>
            <a:r>
              <a:rPr lang="en-US" sz="2200"/>
              <a:t>Fourth level</a:t>
            </a:r>
          </a:p>
          <a:p>
            <a:pPr lvl="4">
              <a:defRPr sz="1800"/>
            </a:pPr>
            <a:r>
              <a:rPr lang="en-US" sz="2200"/>
              <a:t>Fifth level</a:t>
            </a:r>
            <a:endParaRPr sz="2200"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- T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Shape 16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lang="en-US" sz="5600"/>
              <a:t>Click to edit Master title style</a:t>
            </a:r>
            <a:endParaRPr sz="5600"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&amp; 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Shape 18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lang="en-US" sz="5600"/>
              <a:t>Click to edit Master title style</a:t>
            </a:r>
            <a:endParaRPr sz="5600"/>
          </a:p>
        </p:txBody>
      </p:sp>
      <p:sp>
        <p:nvSpPr>
          <p:cNvPr id="19" name="Shape 19"/>
          <p:cNvSpPr>
            <a:spLocks noGrp="1"/>
          </p:cNvSpPr>
          <p:nvPr>
            <p:ph type="body" idx="1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lang="en-US" sz="2500"/>
              <a:t>Edit Master text styles</a:t>
            </a:r>
          </a:p>
          <a:p>
            <a:pPr lvl="1">
              <a:defRPr sz="1800"/>
            </a:pPr>
            <a:r>
              <a:rPr lang="en-US" sz="2500"/>
              <a:t>Second level</a:t>
            </a:r>
          </a:p>
          <a:p>
            <a:pPr lvl="2">
              <a:defRPr sz="1800"/>
            </a:pPr>
            <a:r>
              <a:rPr lang="en-US" sz="2500"/>
              <a:t>Third level</a:t>
            </a:r>
          </a:p>
          <a:p>
            <a:pPr lvl="3">
              <a:defRPr sz="1800"/>
            </a:pPr>
            <a:r>
              <a:rPr lang="en-US" sz="2500"/>
              <a:t>Fourth level</a:t>
            </a:r>
          </a:p>
          <a:p>
            <a:pPr lvl="4">
              <a:defRPr sz="1800"/>
            </a:pPr>
            <a:r>
              <a:rPr lang="en-US" sz="2500"/>
              <a:t>Fifth level</a:t>
            </a:r>
            <a:endParaRPr sz="2500"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, Bullets &amp; Pho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Shape 21"/>
          <p:cNvSpPr>
            <a:spLocks noGrp="1"/>
          </p:cNvSpPr>
          <p:nvPr>
            <p:ph type="title"/>
          </p:nvPr>
        </p:nvSpPr>
        <p:spPr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lang="en-US" sz="5600"/>
              <a:t>Click to edit Master title style</a:t>
            </a:r>
            <a:endParaRPr sz="5600"/>
          </a:p>
        </p:txBody>
      </p:sp>
      <p:sp>
        <p:nvSpPr>
          <p:cNvPr id="22" name="Shape 22"/>
          <p:cNvSpPr>
            <a:spLocks noGrp="1"/>
          </p:cNvSpPr>
          <p:nvPr>
            <p:ph type="body" idx="1"/>
          </p:nvPr>
        </p:nvSpPr>
        <p:spPr>
          <a:xfrm>
            <a:off x="669726" y="1830586"/>
            <a:ext cx="3750469" cy="4420195"/>
          </a:xfrm>
          <a:prstGeom prst="rect">
            <a:avLst/>
          </a:prstGeom>
        </p:spPr>
        <p:txBody>
          <a:bodyPr/>
          <a:lstStyle>
            <a:lvl1pPr marL="241093" indent="-241093">
              <a:spcBef>
                <a:spcPts val="2250"/>
              </a:spcBef>
              <a:defRPr sz="2000"/>
            </a:lvl1pPr>
            <a:lvl2pPr marL="482186" indent="-241093">
              <a:spcBef>
                <a:spcPts val="2250"/>
              </a:spcBef>
              <a:defRPr sz="2000"/>
            </a:lvl2pPr>
            <a:lvl3pPr marL="723279" indent="-241093">
              <a:spcBef>
                <a:spcPts val="2250"/>
              </a:spcBef>
              <a:defRPr sz="2000"/>
            </a:lvl3pPr>
            <a:lvl4pPr marL="964372" indent="-241093">
              <a:spcBef>
                <a:spcPts val="2250"/>
              </a:spcBef>
              <a:defRPr sz="2000"/>
            </a:lvl4pPr>
            <a:lvl5pPr marL="1205465" indent="-241093">
              <a:spcBef>
                <a:spcPts val="2250"/>
              </a:spcBef>
              <a:defRPr sz="2000"/>
            </a:lvl5pPr>
          </a:lstStyle>
          <a:p>
            <a:pPr lvl="0">
              <a:defRPr sz="1800"/>
            </a:pPr>
            <a:r>
              <a:rPr lang="en-US" sz="2000"/>
              <a:t>Edit Master text styles</a:t>
            </a:r>
          </a:p>
          <a:p>
            <a:pPr lvl="1">
              <a:defRPr sz="1800"/>
            </a:pPr>
            <a:r>
              <a:rPr lang="en-US" sz="2000"/>
              <a:t>Second level</a:t>
            </a:r>
          </a:p>
          <a:p>
            <a:pPr lvl="2">
              <a:defRPr sz="1800"/>
            </a:pPr>
            <a:r>
              <a:rPr lang="en-US" sz="2000"/>
              <a:t>Third level</a:t>
            </a:r>
          </a:p>
          <a:p>
            <a:pPr lvl="3">
              <a:defRPr sz="1800"/>
            </a:pPr>
            <a:r>
              <a:rPr lang="en-US" sz="2000"/>
              <a:t>Fourth level</a:t>
            </a:r>
          </a:p>
          <a:p>
            <a:pPr lvl="4">
              <a:defRPr sz="1800"/>
            </a:pPr>
            <a:r>
              <a:rPr lang="en-US" sz="2000"/>
              <a:t>Fifth level</a:t>
            </a:r>
            <a:endParaRPr sz="2000"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Bullet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Shape 24"/>
          <p:cNvSpPr>
            <a:spLocks noGrp="1"/>
          </p:cNvSpPr>
          <p:nvPr>
            <p:ph type="body" idx="1"/>
          </p:nvPr>
        </p:nvSpPr>
        <p:spPr>
          <a:xfrm>
            <a:off x="669727" y="892969"/>
            <a:ext cx="7804547" cy="5072063"/>
          </a:xfrm>
          <a:prstGeom prst="rect">
            <a:avLst/>
          </a:prstGeom>
        </p:spPr>
        <p:txBody>
          <a:bodyPr/>
          <a:lstStyle/>
          <a:p>
            <a:pPr lvl="0">
              <a:defRPr sz="1800"/>
            </a:pPr>
            <a:r>
              <a:rPr lang="en-US" sz="2500"/>
              <a:t>Edit Master text styles</a:t>
            </a:r>
          </a:p>
          <a:p>
            <a:pPr lvl="1">
              <a:defRPr sz="1800"/>
            </a:pPr>
            <a:r>
              <a:rPr lang="en-US" sz="2500"/>
              <a:t>Second level</a:t>
            </a:r>
          </a:p>
          <a:p>
            <a:pPr lvl="2">
              <a:defRPr sz="1800"/>
            </a:pPr>
            <a:r>
              <a:rPr lang="en-US" sz="2500"/>
              <a:t>Third level</a:t>
            </a:r>
          </a:p>
          <a:p>
            <a:pPr lvl="3">
              <a:defRPr sz="1800"/>
            </a:pPr>
            <a:r>
              <a:rPr lang="en-US" sz="2500"/>
              <a:t>Fourth level</a:t>
            </a:r>
          </a:p>
          <a:p>
            <a:pPr lvl="4">
              <a:defRPr sz="1800"/>
            </a:pPr>
            <a:r>
              <a:rPr lang="en-US" sz="2500"/>
              <a:t>Fifth level</a:t>
            </a:r>
            <a:endParaRPr sz="2500"/>
          </a:p>
        </p:txBody>
      </p:sp>
    </p:spTree>
  </p:cSld>
  <p:clrMapOvr>
    <a:masterClrMapping/>
  </p:clrMapOvr>
  <p:transition xmlns:p14="http://schemas.microsoft.com/office/powerpoint/2010/main" spd="med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Photo - 3 U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xmlns:p14="http://schemas.microsoft.com/office/powerpoint/2010/main" spd="med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Quo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Ovr>
    <a:masterClrMapping/>
  </p:clrMapOvr>
  <p:transition xmlns:p14="http://schemas.microsoft.com/office/powerpoint/2010/main" spd="med"/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hape 2"/>
          <p:cNvSpPr>
            <a:spLocks noGrp="1"/>
          </p:cNvSpPr>
          <p:nvPr>
            <p:ph type="title"/>
          </p:nvPr>
        </p:nvSpPr>
        <p:spPr>
          <a:xfrm>
            <a:off x="669727" y="312539"/>
            <a:ext cx="7804547" cy="1518047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0" tIns="0" rIns="0" bIns="0" anchor="ctr">
            <a:normAutofit/>
          </a:bodyPr>
          <a:lstStyle/>
          <a:p>
            <a:pPr lvl="0">
              <a:defRPr sz="1800"/>
            </a:pPr>
            <a:r>
              <a:rPr sz="5600"/>
              <a:t>Title Text</a:t>
            </a:r>
          </a:p>
        </p:txBody>
      </p:sp>
      <p:sp>
        <p:nvSpPr>
          <p:cNvPr id="3" name="Shape 3"/>
          <p:cNvSpPr>
            <a:spLocks noGrp="1"/>
          </p:cNvSpPr>
          <p:nvPr>
            <p:ph type="body" idx="1"/>
          </p:nvPr>
        </p:nvSpPr>
        <p:spPr>
          <a:xfrm>
            <a:off x="669727" y="1830586"/>
            <a:ext cx="7804547" cy="4420195"/>
          </a:xfrm>
          <a:prstGeom prst="rect">
            <a:avLst/>
          </a:prstGeom>
          <a:ln w="12700">
            <a:miter lim="400000"/>
          </a:ln>
          <a:extLst>
            <a:ext uri="{C572A759-6A51-4108-AA02-DFA0A04FC94B}">
              <ma14:wrappingTextBoxFlag xmlns:ma14="http://schemas.microsoft.com/office/mac/drawingml/2011/main" val="1"/>
            </a:ext>
          </a:extLst>
        </p:spPr>
        <p:txBody>
          <a:bodyPr lIns="0" tIns="0" rIns="0" bIns="0" anchor="ctr">
            <a:normAutofit/>
          </a:bodyPr>
          <a:lstStyle/>
          <a:p>
            <a:pPr lvl="0">
              <a:defRPr sz="1800"/>
            </a:pPr>
            <a:r>
              <a:rPr sz="2500"/>
              <a:t>Body Level One</a:t>
            </a:r>
          </a:p>
          <a:p>
            <a:pPr lvl="1">
              <a:defRPr sz="1800"/>
            </a:pPr>
            <a:r>
              <a:rPr sz="2500"/>
              <a:t>Body Level Two</a:t>
            </a:r>
          </a:p>
          <a:p>
            <a:pPr lvl="2">
              <a:defRPr sz="1800"/>
            </a:pPr>
            <a:r>
              <a:rPr sz="2500"/>
              <a:t>Body Level Three</a:t>
            </a:r>
          </a:p>
          <a:p>
            <a:pPr lvl="3">
              <a:defRPr sz="1800"/>
            </a:pPr>
            <a:r>
              <a:rPr sz="2500"/>
              <a:t>Body Level Four</a:t>
            </a:r>
          </a:p>
          <a:p>
            <a:pPr lvl="4">
              <a:defRPr sz="1800"/>
            </a:pPr>
            <a:r>
              <a:rPr sz="2500"/>
              <a:t>Body Level Five</a:t>
            </a: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  <p:sldLayoutId id="2147483660" r:id="rId11"/>
  </p:sldLayoutIdLst>
  <p:transition xmlns:p14="http://schemas.microsoft.com/office/powerpoint/2010/main" spd="med"/>
  <p:txStyles>
    <p:titleStyle>
      <a:lvl1pPr algn="ctr" defTabSz="410751" eaLnBrk="1" hangingPunct="1">
        <a:defRPr sz="5600">
          <a:latin typeface="+mn-lt"/>
          <a:ea typeface="+mn-ea"/>
          <a:cs typeface="+mn-cs"/>
          <a:sym typeface="Helvetica Light"/>
        </a:defRPr>
      </a:lvl1pPr>
      <a:lvl2pPr indent="160729" algn="ctr" defTabSz="410751" eaLnBrk="1" hangingPunct="1">
        <a:defRPr sz="5600">
          <a:latin typeface="+mn-lt"/>
          <a:ea typeface="+mn-ea"/>
          <a:cs typeface="+mn-cs"/>
          <a:sym typeface="Helvetica Light"/>
        </a:defRPr>
      </a:lvl2pPr>
      <a:lvl3pPr indent="321457" algn="ctr" defTabSz="410751" eaLnBrk="1" hangingPunct="1">
        <a:defRPr sz="5600">
          <a:latin typeface="+mn-lt"/>
          <a:ea typeface="+mn-ea"/>
          <a:cs typeface="+mn-cs"/>
          <a:sym typeface="Helvetica Light"/>
        </a:defRPr>
      </a:lvl3pPr>
      <a:lvl4pPr indent="482186" algn="ctr" defTabSz="410751" eaLnBrk="1" hangingPunct="1">
        <a:defRPr sz="5600">
          <a:latin typeface="+mn-lt"/>
          <a:ea typeface="+mn-ea"/>
          <a:cs typeface="+mn-cs"/>
          <a:sym typeface="Helvetica Light"/>
        </a:defRPr>
      </a:lvl4pPr>
      <a:lvl5pPr indent="642915" algn="ctr" defTabSz="410751" eaLnBrk="1" hangingPunct="1">
        <a:defRPr sz="5600">
          <a:latin typeface="+mn-lt"/>
          <a:ea typeface="+mn-ea"/>
          <a:cs typeface="+mn-cs"/>
          <a:sym typeface="Helvetica Light"/>
        </a:defRPr>
      </a:lvl5pPr>
      <a:lvl6pPr indent="803643" algn="ctr" defTabSz="410751" eaLnBrk="1" hangingPunct="1">
        <a:defRPr sz="5600">
          <a:latin typeface="+mn-lt"/>
          <a:ea typeface="+mn-ea"/>
          <a:cs typeface="+mn-cs"/>
          <a:sym typeface="Helvetica Light"/>
        </a:defRPr>
      </a:lvl6pPr>
      <a:lvl7pPr indent="964372" algn="ctr" defTabSz="410751" eaLnBrk="1" hangingPunct="1">
        <a:defRPr sz="5600">
          <a:latin typeface="+mn-lt"/>
          <a:ea typeface="+mn-ea"/>
          <a:cs typeface="+mn-cs"/>
          <a:sym typeface="Helvetica Light"/>
        </a:defRPr>
      </a:lvl7pPr>
      <a:lvl8pPr indent="1125101" algn="ctr" defTabSz="410751" eaLnBrk="1" hangingPunct="1">
        <a:defRPr sz="5600">
          <a:latin typeface="+mn-lt"/>
          <a:ea typeface="+mn-ea"/>
          <a:cs typeface="+mn-cs"/>
          <a:sym typeface="Helvetica Light"/>
        </a:defRPr>
      </a:lvl8pPr>
      <a:lvl9pPr indent="1285829" algn="ctr" defTabSz="410751" eaLnBrk="1" hangingPunct="1">
        <a:defRPr sz="5600">
          <a:latin typeface="+mn-lt"/>
          <a:ea typeface="+mn-ea"/>
          <a:cs typeface="+mn-cs"/>
          <a:sym typeface="Helvetica Light"/>
        </a:defRPr>
      </a:lvl9pPr>
    </p:titleStyle>
    <p:bodyStyle>
      <a:lvl1pPr marL="312528" indent="-312528" defTabSz="410751" eaLnBrk="1" hangingPunct="1">
        <a:spcBef>
          <a:spcPts val="2953"/>
        </a:spcBef>
        <a:buSzPct val="75000"/>
        <a:buChar char="•"/>
        <a:defRPr sz="2500">
          <a:latin typeface="+mn-lt"/>
          <a:ea typeface="+mn-ea"/>
          <a:cs typeface="+mn-cs"/>
          <a:sym typeface="Helvetica Light"/>
        </a:defRPr>
      </a:lvl1pPr>
      <a:lvl2pPr marL="625056" indent="-312528" defTabSz="410751" eaLnBrk="1" hangingPunct="1">
        <a:spcBef>
          <a:spcPts val="2953"/>
        </a:spcBef>
        <a:buSzPct val="75000"/>
        <a:buChar char="•"/>
        <a:defRPr sz="2500">
          <a:latin typeface="+mn-lt"/>
          <a:ea typeface="+mn-ea"/>
          <a:cs typeface="+mn-cs"/>
          <a:sym typeface="Helvetica Light"/>
        </a:defRPr>
      </a:lvl2pPr>
      <a:lvl3pPr marL="937584" indent="-312528" defTabSz="410751" eaLnBrk="1" hangingPunct="1">
        <a:spcBef>
          <a:spcPts val="2953"/>
        </a:spcBef>
        <a:buSzPct val="75000"/>
        <a:buChar char="•"/>
        <a:defRPr sz="2500">
          <a:latin typeface="+mn-lt"/>
          <a:ea typeface="+mn-ea"/>
          <a:cs typeface="+mn-cs"/>
          <a:sym typeface="Helvetica Light"/>
        </a:defRPr>
      </a:lvl3pPr>
      <a:lvl4pPr marL="1250112" indent="-312528" defTabSz="410751" eaLnBrk="1" hangingPunct="1">
        <a:spcBef>
          <a:spcPts val="2953"/>
        </a:spcBef>
        <a:buSzPct val="75000"/>
        <a:buChar char="•"/>
        <a:defRPr sz="2500">
          <a:latin typeface="+mn-lt"/>
          <a:ea typeface="+mn-ea"/>
          <a:cs typeface="+mn-cs"/>
          <a:sym typeface="Helvetica Light"/>
        </a:defRPr>
      </a:lvl4pPr>
      <a:lvl5pPr marL="1562640" indent="-312528" defTabSz="410751" eaLnBrk="1" hangingPunct="1">
        <a:spcBef>
          <a:spcPts val="2953"/>
        </a:spcBef>
        <a:buSzPct val="75000"/>
        <a:buChar char="•"/>
        <a:defRPr sz="2500">
          <a:latin typeface="+mn-lt"/>
          <a:ea typeface="+mn-ea"/>
          <a:cs typeface="+mn-cs"/>
          <a:sym typeface="Helvetica Light"/>
        </a:defRPr>
      </a:lvl5pPr>
      <a:lvl6pPr marL="1875168" indent="-312528" defTabSz="410751" eaLnBrk="1" hangingPunct="1">
        <a:spcBef>
          <a:spcPts val="2953"/>
        </a:spcBef>
        <a:buSzPct val="75000"/>
        <a:buChar char="•"/>
        <a:defRPr sz="2500">
          <a:latin typeface="+mn-lt"/>
          <a:ea typeface="+mn-ea"/>
          <a:cs typeface="+mn-cs"/>
          <a:sym typeface="Helvetica Light"/>
        </a:defRPr>
      </a:lvl6pPr>
      <a:lvl7pPr marL="2187696" indent="-312528" defTabSz="410751" eaLnBrk="1" hangingPunct="1">
        <a:spcBef>
          <a:spcPts val="2953"/>
        </a:spcBef>
        <a:buSzPct val="75000"/>
        <a:buChar char="•"/>
        <a:defRPr sz="2500">
          <a:latin typeface="+mn-lt"/>
          <a:ea typeface="+mn-ea"/>
          <a:cs typeface="+mn-cs"/>
          <a:sym typeface="Helvetica Light"/>
        </a:defRPr>
      </a:lvl7pPr>
      <a:lvl8pPr marL="2500224" indent="-312528" defTabSz="410751" eaLnBrk="1" hangingPunct="1">
        <a:spcBef>
          <a:spcPts val="2953"/>
        </a:spcBef>
        <a:buSzPct val="75000"/>
        <a:buChar char="•"/>
        <a:defRPr sz="2500">
          <a:latin typeface="+mn-lt"/>
          <a:ea typeface="+mn-ea"/>
          <a:cs typeface="+mn-cs"/>
          <a:sym typeface="Helvetica Light"/>
        </a:defRPr>
      </a:lvl8pPr>
      <a:lvl9pPr marL="2812752" indent="-312528" defTabSz="410751" eaLnBrk="1" hangingPunct="1">
        <a:spcBef>
          <a:spcPts val="2953"/>
        </a:spcBef>
        <a:buSzPct val="75000"/>
        <a:buChar char="•"/>
        <a:defRPr sz="2500">
          <a:latin typeface="+mn-lt"/>
          <a:ea typeface="+mn-ea"/>
          <a:cs typeface="+mn-cs"/>
          <a:sym typeface="Helvetica Light"/>
        </a:defRPr>
      </a:lvl9pPr>
    </p:bodyStyle>
    <p:otherStyle>
      <a:lvl1pPr algn="ctr" defTabSz="410751" eaLnBrk="1" hangingPunct="1">
        <a:defRPr>
          <a:solidFill>
            <a:schemeClr val="tx1"/>
          </a:solidFill>
          <a:latin typeface="+mn-lt"/>
          <a:ea typeface="+mn-ea"/>
          <a:cs typeface="+mn-cs"/>
          <a:sym typeface="Helvetica Light"/>
        </a:defRPr>
      </a:lvl1pPr>
      <a:lvl2pPr indent="160729" algn="ctr" defTabSz="410751" eaLnBrk="1" hangingPunct="1">
        <a:defRPr>
          <a:solidFill>
            <a:schemeClr val="tx1"/>
          </a:solidFill>
          <a:latin typeface="+mn-lt"/>
          <a:ea typeface="+mn-ea"/>
          <a:cs typeface="+mn-cs"/>
          <a:sym typeface="Helvetica Light"/>
        </a:defRPr>
      </a:lvl2pPr>
      <a:lvl3pPr indent="321457" algn="ctr" defTabSz="410751" eaLnBrk="1" hangingPunct="1">
        <a:defRPr>
          <a:solidFill>
            <a:schemeClr val="tx1"/>
          </a:solidFill>
          <a:latin typeface="+mn-lt"/>
          <a:ea typeface="+mn-ea"/>
          <a:cs typeface="+mn-cs"/>
          <a:sym typeface="Helvetica Light"/>
        </a:defRPr>
      </a:lvl3pPr>
      <a:lvl4pPr indent="482186" algn="ctr" defTabSz="410751" eaLnBrk="1" hangingPunct="1">
        <a:defRPr>
          <a:solidFill>
            <a:schemeClr val="tx1"/>
          </a:solidFill>
          <a:latin typeface="+mn-lt"/>
          <a:ea typeface="+mn-ea"/>
          <a:cs typeface="+mn-cs"/>
          <a:sym typeface="Helvetica Light"/>
        </a:defRPr>
      </a:lvl4pPr>
      <a:lvl5pPr indent="642915" algn="ctr" defTabSz="410751" eaLnBrk="1" hangingPunct="1">
        <a:defRPr>
          <a:solidFill>
            <a:schemeClr val="tx1"/>
          </a:solidFill>
          <a:latin typeface="+mn-lt"/>
          <a:ea typeface="+mn-ea"/>
          <a:cs typeface="+mn-cs"/>
          <a:sym typeface="Helvetica Light"/>
        </a:defRPr>
      </a:lvl5pPr>
      <a:lvl6pPr indent="803643" algn="ctr" defTabSz="410751" eaLnBrk="1" hangingPunct="1">
        <a:defRPr>
          <a:solidFill>
            <a:schemeClr val="tx1"/>
          </a:solidFill>
          <a:latin typeface="+mn-lt"/>
          <a:ea typeface="+mn-ea"/>
          <a:cs typeface="+mn-cs"/>
          <a:sym typeface="Helvetica Light"/>
        </a:defRPr>
      </a:lvl6pPr>
      <a:lvl7pPr indent="964372" algn="ctr" defTabSz="410751" eaLnBrk="1" hangingPunct="1">
        <a:defRPr>
          <a:solidFill>
            <a:schemeClr val="tx1"/>
          </a:solidFill>
          <a:latin typeface="+mn-lt"/>
          <a:ea typeface="+mn-ea"/>
          <a:cs typeface="+mn-cs"/>
          <a:sym typeface="Helvetica Light"/>
        </a:defRPr>
      </a:lvl7pPr>
      <a:lvl8pPr indent="1125101" algn="ctr" defTabSz="410751" eaLnBrk="1" hangingPunct="1">
        <a:defRPr>
          <a:solidFill>
            <a:schemeClr val="tx1"/>
          </a:solidFill>
          <a:latin typeface="+mn-lt"/>
          <a:ea typeface="+mn-ea"/>
          <a:cs typeface="+mn-cs"/>
          <a:sym typeface="Helvetica Light"/>
        </a:defRPr>
      </a:lvl8pPr>
      <a:lvl9pPr indent="1285829" algn="ctr" defTabSz="410751" eaLnBrk="1" hangingPunct="1">
        <a:defRPr>
          <a:solidFill>
            <a:schemeClr val="tx1"/>
          </a:solidFill>
          <a:latin typeface="+mn-lt"/>
          <a:ea typeface="+mn-ea"/>
          <a:cs typeface="+mn-cs"/>
          <a:sym typeface="Helvetica Light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4" Type="http://schemas.openxmlformats.org/officeDocument/2006/relationships/chart" Target="../charts/chart3.xml"/><Relationship Id="rId5" Type="http://schemas.openxmlformats.org/officeDocument/2006/relationships/chart" Target="../charts/chart4.xml"/><Relationship Id="rId1" Type="http://schemas.openxmlformats.org/officeDocument/2006/relationships/slideLayout" Target="../slideLayouts/slideLayout11.xml"/><Relationship Id="rId2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chart" Target="../charts/chart5.xml"/><Relationship Id="rId3" Type="http://schemas.openxmlformats.org/officeDocument/2006/relationships/image" Target="../media/image2.pn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image" Target="../media/image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7.xml"/><Relationship Id="rId4" Type="http://schemas.openxmlformats.org/officeDocument/2006/relationships/chart" Target="../charts/chart8.xml"/><Relationship Id="rId5" Type="http://schemas.openxmlformats.org/officeDocument/2006/relationships/chart" Target="../charts/chart9.xml"/><Relationship Id="rId1" Type="http://schemas.openxmlformats.org/officeDocument/2006/relationships/slideLayout" Target="../slideLayouts/slideLayout11.xml"/><Relationship Id="rId2" Type="http://schemas.openxmlformats.org/officeDocument/2006/relationships/chart" Target="../charts/chart6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chart" Target="../charts/chart10.xml"/><Relationship Id="rId3" Type="http://schemas.openxmlformats.org/officeDocument/2006/relationships/chart" Target="../charts/chart11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Relationship Id="rId2" Type="http://schemas.openxmlformats.org/officeDocument/2006/relationships/image" Target="../media/image4.emf"/><Relationship Id="rId3" Type="http://schemas.openxmlformats.org/officeDocument/2006/relationships/image" Target="../media/image5.emf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035995" y="932707"/>
            <a:ext cx="2657293" cy="5140484"/>
            <a:chOff x="9272241" y="1836050"/>
            <a:chExt cx="2657292" cy="5140484"/>
          </a:xfrm>
        </p:grpSpPr>
        <p:sp>
          <p:nvSpPr>
            <p:cNvPr id="3" name="TextBox 2"/>
            <p:cNvSpPr txBox="1"/>
            <p:nvPr/>
          </p:nvSpPr>
          <p:spPr>
            <a:xfrm rot="16200000">
              <a:off x="8613199" y="2495092"/>
              <a:ext cx="1666898" cy="348813"/>
            </a:xfrm>
            <a:prstGeom prst="rect">
              <a:avLst/>
            </a:prstGeom>
            <a:noFill/>
            <a:ln w="12700" cap="flat">
              <a:noFill/>
              <a:miter lim="400000"/>
            </a:ln>
            <a:effectLst/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none"/>
          </p:style>
          <p:txBody>
            <a:bodyPr rot="0" spcFirstLastPara="1" vertOverflow="overflow" horzOverflow="overflow" vert="horz" wrap="square" lIns="50800" tIns="50800" rIns="50800" bIns="50800" numCol="1" spcCol="38100" rtlCol="0" anchor="ctr">
              <a:spAutoFit/>
            </a:bodyPr>
            <a:lstStyle/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/>
                  <a:ea typeface="+mn-ea"/>
                  <a:cs typeface="Arial"/>
                  <a:sym typeface="Helvetica Light"/>
                </a:rPr>
                <a:t>Gene expression </a:t>
              </a:r>
            </a:p>
            <a:p>
              <a:pPr marL="0" marR="0" indent="0" algn="ctr" defTabSz="584200" rtl="0" fontAlgn="auto" latinLnBrk="1" hangingPunct="0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</a:pPr>
              <a:r>
                <a:rPr kumimoji="0" lang="en-US" sz="800" i="0" u="none" strike="noStrike" cap="none" spc="0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uFillTx/>
                  <a:latin typeface="Arial"/>
                  <a:ea typeface="+mn-ea"/>
                  <a:cs typeface="Arial"/>
                  <a:sym typeface="Helvetica Light"/>
                </a:rPr>
                <a:t>(fold of control)</a:t>
              </a:r>
            </a:p>
          </p:txBody>
        </p:sp>
        <p:grpSp>
          <p:nvGrpSpPr>
            <p:cNvPr id="4" name="Group 3"/>
            <p:cNvGrpSpPr/>
            <p:nvPr/>
          </p:nvGrpSpPr>
          <p:grpSpPr>
            <a:xfrm>
              <a:off x="9272241" y="2186099"/>
              <a:ext cx="2657292" cy="4790435"/>
              <a:chOff x="9272241" y="2186099"/>
              <a:chExt cx="2657292" cy="4790435"/>
            </a:xfrm>
          </p:grpSpPr>
          <p:graphicFrame>
            <p:nvGraphicFramePr>
              <p:cNvPr id="6" name="Chart 5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484713727"/>
                  </p:ext>
                </p:extLst>
              </p:nvPr>
            </p:nvGraphicFramePr>
            <p:xfrm>
              <a:off x="9486682" y="2186099"/>
              <a:ext cx="2434385" cy="1352968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7" name="Chart 6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013365449"/>
                  </p:ext>
                </p:extLst>
              </p:nvPr>
            </p:nvGraphicFramePr>
            <p:xfrm>
              <a:off x="9415471" y="3301999"/>
              <a:ext cx="2454795" cy="1397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8" name="Chart 7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434391063"/>
                  </p:ext>
                </p:extLst>
              </p:nvPr>
            </p:nvGraphicFramePr>
            <p:xfrm>
              <a:off x="9457267" y="4475182"/>
              <a:ext cx="2391833" cy="118902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9" name="Chart 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368136867"/>
                  </p:ext>
                </p:extLst>
              </p:nvPr>
            </p:nvGraphicFramePr>
            <p:xfrm>
              <a:off x="9486871" y="5604933"/>
              <a:ext cx="2442662" cy="137160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10" name="TextBox 9"/>
              <p:cNvSpPr txBox="1"/>
              <p:nvPr/>
            </p:nvSpPr>
            <p:spPr>
              <a:xfrm rot="16200000">
                <a:off x="8613199" y="3680429"/>
                <a:ext cx="1666898" cy="34881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pPr marL="0" marR="0" indent="0" algn="ctr" defTabSz="584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/>
                    <a:ea typeface="+mn-ea"/>
                    <a:cs typeface="Arial"/>
                    <a:sym typeface="Helvetica Light"/>
                  </a:rPr>
                  <a:t>Gene expression </a:t>
                </a:r>
              </a:p>
              <a:p>
                <a:pPr marL="0" marR="0" indent="0" algn="ctr" defTabSz="584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/>
                    <a:ea typeface="+mn-ea"/>
                    <a:cs typeface="Arial"/>
                    <a:sym typeface="Helvetica Light"/>
                  </a:rPr>
                  <a:t>(fold of control)</a:t>
                </a: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 rot="16200000">
                <a:off x="8613200" y="4679493"/>
                <a:ext cx="1666898" cy="34881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pPr marL="0" marR="0" indent="0" algn="ctr" defTabSz="584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/>
                    <a:ea typeface="+mn-ea"/>
                    <a:cs typeface="Arial"/>
                    <a:sym typeface="Helvetica Light"/>
                  </a:rPr>
                  <a:t>Gene expression </a:t>
                </a:r>
              </a:p>
              <a:p>
                <a:pPr marL="0" marR="0" indent="0" algn="ctr" defTabSz="584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/>
                    <a:ea typeface="+mn-ea"/>
                    <a:cs typeface="Arial"/>
                    <a:sym typeface="Helvetica Light"/>
                  </a:rPr>
                  <a:t>(fold of control)</a:t>
                </a:r>
              </a:p>
            </p:txBody>
          </p:sp>
          <p:sp>
            <p:nvSpPr>
              <p:cNvPr id="12" name="TextBox 11"/>
              <p:cNvSpPr txBox="1"/>
              <p:nvPr/>
            </p:nvSpPr>
            <p:spPr>
              <a:xfrm rot="16200000">
                <a:off x="8613200" y="5807809"/>
                <a:ext cx="1666898" cy="348813"/>
              </a:xfrm>
              <a:prstGeom prst="rect">
                <a:avLst/>
              </a:prstGeom>
              <a:noFill/>
              <a:ln w="12700" cap="flat">
                <a:noFill/>
                <a:miter lim="400000"/>
              </a:ln>
              <a:effectLst/>
            </p:spPr>
            <p:style>
              <a:lnRef idx="0">
                <a:scrgbClr r="0" g="0" b="0"/>
              </a:lnRef>
              <a:fillRef idx="0">
                <a:scrgbClr r="0" g="0" b="0"/>
              </a:fillRef>
              <a:effectRef idx="0">
                <a:scrgbClr r="0" g="0" b="0"/>
              </a:effectRef>
              <a:fontRef idx="none"/>
            </p:style>
            <p:txBody>
              <a:bodyPr rot="0" spcFirstLastPara="1" vertOverflow="overflow" horzOverflow="overflow" vert="horz" wrap="square" lIns="50800" tIns="50800" rIns="50800" bIns="50800" numCol="1" spcCol="38100" rtlCol="0" anchor="ctr">
                <a:spAutoFit/>
              </a:bodyPr>
              <a:lstStyle/>
              <a:p>
                <a:pPr marL="0" marR="0" indent="0" algn="ctr" defTabSz="584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/>
                    <a:ea typeface="+mn-ea"/>
                    <a:cs typeface="Arial"/>
                    <a:sym typeface="Helvetica Light"/>
                  </a:rPr>
                  <a:t>Gene expression </a:t>
                </a:r>
              </a:p>
              <a:p>
                <a:pPr marL="0" marR="0" indent="0" algn="ctr" defTabSz="584200" rtl="0" fontAlgn="auto" latinLnBrk="1" hangingPunct="0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sz="800" i="0" u="none" strike="noStrike" cap="none" spc="0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uFillTx/>
                    <a:latin typeface="Arial"/>
                    <a:ea typeface="+mn-ea"/>
                    <a:cs typeface="Arial"/>
                    <a:sym typeface="Helvetica Light"/>
                  </a:rPr>
                  <a:t>(fold of control)</a:t>
                </a:r>
              </a:p>
            </p:txBody>
          </p:sp>
        </p:grpSp>
      </p:grpSp>
      <p:sp>
        <p:nvSpPr>
          <p:cNvPr id="13" name="TextBox 12"/>
          <p:cNvSpPr txBox="1"/>
          <p:nvPr/>
        </p:nvSpPr>
        <p:spPr>
          <a:xfrm>
            <a:off x="5941951" y="5963545"/>
            <a:ext cx="1388522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b="1" dirty="0">
                <a:latin typeface="Arial"/>
                <a:cs typeface="Arial"/>
              </a:rPr>
              <a:t>Supplementary Figure 1</a:t>
            </a:r>
          </a:p>
        </p:txBody>
      </p:sp>
    </p:spTree>
    <p:extLst>
      <p:ext uri="{BB962C8B-B14F-4D97-AF65-F5344CB8AC3E}">
        <p14:creationId xmlns:p14="http://schemas.microsoft.com/office/powerpoint/2010/main" val="2414412672"/>
      </p:ext>
    </p:extLst>
  </p:cSld>
  <p:clrMapOvr>
    <a:masterClrMapping/>
  </p:clrMapOvr>
  <p:transition xmlns:p14="http://schemas.microsoft.com/office/powerpoint/2010/main" spd="med"/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2824609" y="2209503"/>
          <a:ext cx="3193256" cy="24338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4" name="Picture 3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26729" y="2408026"/>
            <a:ext cx="1233443" cy="505781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5102526" y="5172771"/>
            <a:ext cx="1390124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b="1" dirty="0">
                <a:latin typeface="Arial"/>
                <a:cs typeface="Arial"/>
              </a:rPr>
              <a:t>Supplementary Figure </a:t>
            </a:r>
            <a:r>
              <a:rPr lang="en-US" sz="825" b="1" dirty="0" smtClean="0">
                <a:latin typeface="Arial"/>
                <a:cs typeface="Arial"/>
              </a:rPr>
              <a:t>2</a:t>
            </a:r>
            <a:endParaRPr lang="en-US" sz="825" b="1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061460674"/>
      </p:ext>
    </p:extLst>
  </p:cSld>
  <p:clrMapOvr>
    <a:masterClrMapping/>
  </p:clrMapOvr>
  <p:transition xmlns:p14="http://schemas.microsoft.com/office/powerpoint/2010/main" spd="med"/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9" name="Picture 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24599" y="1669822"/>
            <a:ext cx="3946683" cy="2989491"/>
          </a:xfrm>
          <a:prstGeom prst="rect">
            <a:avLst/>
          </a:prstGeom>
        </p:spPr>
      </p:pic>
      <p:sp>
        <p:nvSpPr>
          <p:cNvPr id="20" name="TextBox 19"/>
          <p:cNvSpPr txBox="1"/>
          <p:nvPr/>
        </p:nvSpPr>
        <p:spPr>
          <a:xfrm>
            <a:off x="2685559" y="1780048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651525" y="2940616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5544144" y="5136826"/>
            <a:ext cx="1388522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b="1" dirty="0">
                <a:latin typeface="Arial"/>
                <a:cs typeface="Arial"/>
              </a:rPr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3536084894"/>
      </p:ext>
    </p:extLst>
  </p:cSld>
  <p:clrMapOvr>
    <a:masterClrMapping/>
  </p:clrMapOvr>
  <p:transition xmlns:p14="http://schemas.microsoft.com/office/powerpoint/2010/main" spd="med"/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/>
          </p:nvPr>
        </p:nvGraphicFramePr>
        <p:xfrm>
          <a:off x="1274686" y="1876425"/>
          <a:ext cx="2688071" cy="1633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/>
          <p:cNvGraphicFramePr>
            <a:graphicFrameLocks/>
          </p:cNvGraphicFramePr>
          <p:nvPr>
            <p:extLst/>
          </p:nvPr>
        </p:nvGraphicFramePr>
        <p:xfrm>
          <a:off x="1281166" y="3727761"/>
          <a:ext cx="2688071" cy="1633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4154054" y="1887687"/>
          <a:ext cx="2688071" cy="1633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5" name="Chart 4"/>
          <p:cNvGraphicFramePr>
            <a:graphicFrameLocks/>
          </p:cNvGraphicFramePr>
          <p:nvPr>
            <p:extLst/>
          </p:nvPr>
        </p:nvGraphicFramePr>
        <p:xfrm>
          <a:off x="4147705" y="3720219"/>
          <a:ext cx="2688071" cy="163368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6039933" y="5609368"/>
            <a:ext cx="1390124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b="1" dirty="0">
                <a:latin typeface="Arial"/>
                <a:cs typeface="Arial"/>
              </a:rPr>
              <a:t>Supplementary Figure </a:t>
            </a:r>
            <a:r>
              <a:rPr lang="en-US" sz="825" b="1" dirty="0" smtClean="0">
                <a:latin typeface="Arial"/>
                <a:cs typeface="Arial"/>
              </a:rPr>
              <a:t>4</a:t>
            </a:r>
            <a:endParaRPr lang="en-US" sz="825" b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265806" y="1903837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280362" y="3713425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161406" y="1884787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2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175962" y="3732475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25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595934060"/>
      </p:ext>
    </p:extLst>
  </p:cSld>
  <p:clrMapOvr>
    <a:masterClrMapping/>
  </p:clrMapOvr>
  <p:transition xmlns:p14="http://schemas.microsoft.com/office/powerpoint/2010/main" spd="med"/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/>
          <p:cNvGraphicFramePr>
            <a:graphicFrameLocks/>
          </p:cNvGraphicFramePr>
          <p:nvPr>
            <p:extLst/>
          </p:nvPr>
        </p:nvGraphicFramePr>
        <p:xfrm>
          <a:off x="636327" y="1172002"/>
          <a:ext cx="3429000" cy="20574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Chart 3"/>
          <p:cNvGraphicFramePr>
            <a:graphicFrameLocks/>
          </p:cNvGraphicFramePr>
          <p:nvPr>
            <p:extLst/>
          </p:nvPr>
        </p:nvGraphicFramePr>
        <p:xfrm>
          <a:off x="4383605" y="1229580"/>
          <a:ext cx="3564000" cy="26535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5" name="Group 4"/>
          <p:cNvGrpSpPr/>
          <p:nvPr/>
        </p:nvGrpSpPr>
        <p:grpSpPr>
          <a:xfrm>
            <a:off x="1500796" y="1514487"/>
            <a:ext cx="2314673" cy="511814"/>
            <a:chOff x="5863993" y="555831"/>
            <a:chExt cx="1936226" cy="682419"/>
          </a:xfrm>
        </p:grpSpPr>
        <p:grpSp>
          <p:nvGrpSpPr>
            <p:cNvPr id="6" name="Group 5"/>
            <p:cNvGrpSpPr/>
            <p:nvPr/>
          </p:nvGrpSpPr>
          <p:grpSpPr>
            <a:xfrm>
              <a:off x="5863993" y="560252"/>
              <a:ext cx="1881185" cy="677998"/>
              <a:chOff x="2127634" y="607620"/>
              <a:chExt cx="1881185" cy="677998"/>
            </a:xfrm>
          </p:grpSpPr>
          <p:cxnSp>
            <p:nvCxnSpPr>
              <p:cNvPr id="10" name="Straight Connector 9"/>
              <p:cNvCxnSpPr/>
              <p:nvPr/>
            </p:nvCxnSpPr>
            <p:spPr>
              <a:xfrm flipV="1">
                <a:off x="2127634" y="607620"/>
                <a:ext cx="0" cy="67799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" name="Straight Connector 10"/>
              <p:cNvCxnSpPr/>
              <p:nvPr/>
            </p:nvCxnSpPr>
            <p:spPr>
              <a:xfrm>
                <a:off x="2132394" y="709409"/>
                <a:ext cx="628650" cy="202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" name="Straight Connector 11"/>
              <p:cNvCxnSpPr/>
              <p:nvPr/>
            </p:nvCxnSpPr>
            <p:spPr>
              <a:xfrm flipV="1">
                <a:off x="2761044" y="711429"/>
                <a:ext cx="1" cy="216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" name="Straight Connector 12"/>
              <p:cNvCxnSpPr/>
              <p:nvPr/>
            </p:nvCxnSpPr>
            <p:spPr>
              <a:xfrm flipH="1" flipV="1">
                <a:off x="3388487" y="657277"/>
                <a:ext cx="1" cy="252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/>
              <p:cNvCxnSpPr/>
              <p:nvPr/>
            </p:nvCxnSpPr>
            <p:spPr>
              <a:xfrm flipV="1">
                <a:off x="4008819" y="618774"/>
                <a:ext cx="0" cy="28800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/>
              <p:cNvCxnSpPr/>
              <p:nvPr/>
            </p:nvCxnSpPr>
            <p:spPr>
              <a:xfrm flipV="1">
                <a:off x="2128135" y="657274"/>
                <a:ext cx="1264789" cy="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/>
              <p:cNvCxnSpPr/>
              <p:nvPr/>
            </p:nvCxnSpPr>
            <p:spPr>
              <a:xfrm>
                <a:off x="2132394" y="607620"/>
                <a:ext cx="1876425" cy="111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" name="TextBox 6"/>
            <p:cNvSpPr txBox="1"/>
            <p:nvPr/>
          </p:nvSpPr>
          <p:spPr>
            <a:xfrm>
              <a:off x="6359434" y="641556"/>
              <a:ext cx="228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6974354" y="593931"/>
              <a:ext cx="228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7571619" y="555831"/>
              <a:ext cx="228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5294623" y="1558650"/>
            <a:ext cx="2334269" cy="538418"/>
            <a:chOff x="5863994" y="555831"/>
            <a:chExt cx="1952620" cy="717891"/>
          </a:xfrm>
        </p:grpSpPr>
        <p:grpSp>
          <p:nvGrpSpPr>
            <p:cNvPr id="30" name="Group 29"/>
            <p:cNvGrpSpPr/>
            <p:nvPr/>
          </p:nvGrpSpPr>
          <p:grpSpPr>
            <a:xfrm>
              <a:off x="5863994" y="560252"/>
              <a:ext cx="1881184" cy="713470"/>
              <a:chOff x="2127635" y="607620"/>
              <a:chExt cx="1881184" cy="713470"/>
            </a:xfrm>
          </p:grpSpPr>
          <p:cxnSp>
            <p:nvCxnSpPr>
              <p:cNvPr id="34" name="Straight Connector 33"/>
              <p:cNvCxnSpPr/>
              <p:nvPr/>
            </p:nvCxnSpPr>
            <p:spPr>
              <a:xfrm flipH="1" flipV="1">
                <a:off x="2127635" y="607622"/>
                <a:ext cx="501" cy="71346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/>
              <p:cNvCxnSpPr/>
              <p:nvPr/>
            </p:nvCxnSpPr>
            <p:spPr>
              <a:xfrm>
                <a:off x="2132394" y="709409"/>
                <a:ext cx="628650" cy="202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" name="Straight Connector 35"/>
              <p:cNvCxnSpPr/>
              <p:nvPr/>
            </p:nvCxnSpPr>
            <p:spPr>
              <a:xfrm flipV="1">
                <a:off x="2761044" y="711429"/>
                <a:ext cx="1" cy="8521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Straight Connector 36"/>
              <p:cNvCxnSpPr/>
              <p:nvPr/>
            </p:nvCxnSpPr>
            <p:spPr>
              <a:xfrm flipH="1" flipV="1">
                <a:off x="3388487" y="657277"/>
                <a:ext cx="1" cy="129844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 flipV="1">
                <a:off x="4008819" y="618775"/>
                <a:ext cx="0" cy="177347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 flipV="1">
                <a:off x="2128136" y="657274"/>
                <a:ext cx="1264790" cy="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Straight Connector 39"/>
              <p:cNvCxnSpPr/>
              <p:nvPr/>
            </p:nvCxnSpPr>
            <p:spPr>
              <a:xfrm>
                <a:off x="2132394" y="607620"/>
                <a:ext cx="1876425" cy="11155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1" name="TextBox 30"/>
            <p:cNvSpPr txBox="1"/>
            <p:nvPr/>
          </p:nvSpPr>
          <p:spPr>
            <a:xfrm>
              <a:off x="6321189" y="641556"/>
              <a:ext cx="228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968889" y="593931"/>
              <a:ext cx="228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588014" y="555831"/>
              <a:ext cx="2286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600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53" name="TextBox 52"/>
          <p:cNvSpPr txBox="1"/>
          <p:nvPr/>
        </p:nvSpPr>
        <p:spPr>
          <a:xfrm>
            <a:off x="6801914" y="4225320"/>
            <a:ext cx="1388522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b="1" dirty="0">
                <a:latin typeface="Arial"/>
                <a:cs typeface="Arial"/>
              </a:rPr>
              <a:t>Supplementary Figure </a:t>
            </a:r>
            <a:r>
              <a:rPr lang="tr-TR" sz="825" b="1" dirty="0" smtClean="0">
                <a:latin typeface="Arial"/>
                <a:cs typeface="Arial"/>
              </a:rPr>
              <a:t>5</a:t>
            </a:r>
            <a:endParaRPr lang="en-US" sz="825" b="1" dirty="0">
              <a:latin typeface="Arial"/>
              <a:cs typeface="Arial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494105" y="1263296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523958" y="1250669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18189241"/>
      </p:ext>
    </p:extLst>
  </p:cSld>
  <p:clrMapOvr>
    <a:masterClrMapping/>
  </p:clrMapOvr>
  <p:transition xmlns:p14="http://schemas.microsoft.com/office/powerpoint/2010/main" spd="med"/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6637" y="1480242"/>
            <a:ext cx="2388929" cy="1581681"/>
          </a:xfrm>
          <a:prstGeom prst="rect">
            <a:avLst/>
          </a:prstGeom>
        </p:spPr>
      </p:pic>
      <p:graphicFrame>
        <p:nvGraphicFramePr>
          <p:cNvPr id="4" name="Table 3"/>
          <p:cNvGraphicFramePr>
            <a:graphicFrameLocks noGrp="1"/>
          </p:cNvGraphicFramePr>
          <p:nvPr>
            <p:extLst/>
          </p:nvPr>
        </p:nvGraphicFramePr>
        <p:xfrm>
          <a:off x="3501490" y="2723818"/>
          <a:ext cx="4061965" cy="3810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333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40044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368970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  <a:gridCol w="368971">
                  <a:extLst>
                    <a:ext uri="{9D8B030D-6E8A-4147-A177-3AD203B41FA5}">
                      <a16:colId xmlns:a16="http://schemas.microsoft.com/office/drawing/2014/main" xmlns="" val="20003"/>
                    </a:ext>
                  </a:extLst>
                </a:gridCol>
                <a:gridCol w="435196">
                  <a:extLst>
                    <a:ext uri="{9D8B030D-6E8A-4147-A177-3AD203B41FA5}">
                      <a16:colId xmlns:a16="http://schemas.microsoft.com/office/drawing/2014/main" xmlns="" val="20004"/>
                    </a:ext>
                  </a:extLst>
                </a:gridCol>
                <a:gridCol w="383893">
                  <a:extLst>
                    <a:ext uri="{9D8B030D-6E8A-4147-A177-3AD203B41FA5}">
                      <a16:colId xmlns:a16="http://schemas.microsoft.com/office/drawing/2014/main" xmlns="" val="20005"/>
                    </a:ext>
                  </a:extLst>
                </a:gridCol>
                <a:gridCol w="352795">
                  <a:extLst>
                    <a:ext uri="{9D8B030D-6E8A-4147-A177-3AD203B41FA5}">
                      <a16:colId xmlns:a16="http://schemas.microsoft.com/office/drawing/2014/main" xmlns="" val="20006"/>
                    </a:ext>
                  </a:extLst>
                </a:gridCol>
                <a:gridCol w="396894">
                  <a:extLst>
                    <a:ext uri="{9D8B030D-6E8A-4147-A177-3AD203B41FA5}">
                      <a16:colId xmlns:a16="http://schemas.microsoft.com/office/drawing/2014/main" xmlns="" val="20007"/>
                    </a:ext>
                  </a:extLst>
                </a:gridCol>
                <a:gridCol w="343975">
                  <a:extLst>
                    <a:ext uri="{9D8B030D-6E8A-4147-A177-3AD203B41FA5}">
                      <a16:colId xmlns:a16="http://schemas.microsoft.com/office/drawing/2014/main" xmlns="" val="20008"/>
                    </a:ext>
                  </a:extLst>
                </a:gridCol>
                <a:gridCol w="657494">
                  <a:extLst>
                    <a:ext uri="{9D8B030D-6E8A-4147-A177-3AD203B41FA5}">
                      <a16:colId xmlns:a16="http://schemas.microsoft.com/office/drawing/2014/main" xmlns="" val="20009"/>
                    </a:ext>
                  </a:extLst>
                </a:gridCol>
              </a:tblGrid>
              <a:tr h="182880">
                <a:tc>
                  <a:txBody>
                    <a:bodyPr/>
                    <a:lstStyle/>
                    <a:p>
                      <a:r>
                        <a:rPr lang="en-US" sz="600" b="1" dirty="0" err="1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FasL</a:t>
                      </a:r>
                      <a:endParaRPr lang="en-US" sz="600" b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b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381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82880">
                <a:tc>
                  <a:txBody>
                    <a:bodyPr/>
                    <a:lstStyle/>
                    <a:p>
                      <a:r>
                        <a:rPr lang="en-US" sz="6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HRK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endParaRPr lang="en-US" sz="800" b="1" dirty="0">
                        <a:solidFill>
                          <a:schemeClr val="tx1"/>
                        </a:solidFill>
                        <a:latin typeface="Arial" charset="0"/>
                        <a:ea typeface="Arial" charset="0"/>
                        <a:cs typeface="Arial" charset="0"/>
                      </a:endParaRP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-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US" sz="800" b="1" dirty="0">
                          <a:solidFill>
                            <a:schemeClr val="tx1"/>
                          </a:solidFill>
                          <a:latin typeface="Arial" charset="0"/>
                          <a:ea typeface="Arial" charset="0"/>
                          <a:cs typeface="Arial" charset="0"/>
                        </a:rPr>
                        <a:t>+</a:t>
                      </a:r>
                    </a:p>
                  </a:txBody>
                  <a:tcPr marL="68580" marR="68580" marT="34290" marB="34290" anchor="ctr">
                    <a:lnL w="12700" cmpd="sng">
                      <a:noFill/>
                    </a:lnL>
                    <a:lnR w="12700" cmpd="sng">
                      <a:noFill/>
                    </a:lnR>
                    <a:lnT w="381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</a:tbl>
          </a:graphicData>
        </a:graphic>
      </p:graphicFrame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/>
          <a:srcRect b="7165"/>
          <a:stretch/>
        </p:blipFill>
        <p:spPr>
          <a:xfrm>
            <a:off x="3472627" y="1455779"/>
            <a:ext cx="3790950" cy="1273335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437131" y="1294237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25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385387" y="1322650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25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513903" y="1344967"/>
            <a:ext cx="266132" cy="21929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825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6939113" y="3591193"/>
            <a:ext cx="1388522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b="1" dirty="0">
                <a:latin typeface="Arial"/>
                <a:cs typeface="Arial"/>
              </a:rPr>
              <a:t>Supplementary Figure </a:t>
            </a:r>
            <a:r>
              <a:rPr lang="en-US" sz="825" b="1" dirty="0" smtClean="0">
                <a:latin typeface="Arial"/>
                <a:cs typeface="Arial"/>
              </a:rPr>
              <a:t>6</a:t>
            </a:r>
            <a:endParaRPr lang="en-US" sz="825" b="1" dirty="0">
              <a:latin typeface="Arial"/>
              <a:cs typeface="Arial"/>
            </a:endParaRP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xmlns="" id="{5E491273-54F1-2D46-97DF-2459E92E5717}"/>
              </a:ext>
            </a:extLst>
          </p:cNvPr>
          <p:cNvGrpSpPr/>
          <p:nvPr/>
        </p:nvGrpSpPr>
        <p:grpSpPr>
          <a:xfrm>
            <a:off x="4035224" y="1723506"/>
            <a:ext cx="1014524" cy="208350"/>
            <a:chOff x="1292546" y="3699530"/>
            <a:chExt cx="706400" cy="277799"/>
          </a:xfrm>
        </p:grpSpPr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xmlns="" id="{38E90E60-1800-FD49-B27B-690DB59E1644}"/>
                </a:ext>
              </a:extLst>
            </p:cNvPr>
            <p:cNvSpPr txBox="1"/>
            <p:nvPr/>
          </p:nvSpPr>
          <p:spPr>
            <a:xfrm>
              <a:off x="1403936" y="3761885"/>
              <a:ext cx="1589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45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xmlns="" id="{68DAFD31-1C04-2648-9AF5-87EABD77AD2D}"/>
                </a:ext>
              </a:extLst>
            </p:cNvPr>
            <p:cNvGrpSpPr/>
            <p:nvPr/>
          </p:nvGrpSpPr>
          <p:grpSpPr>
            <a:xfrm>
              <a:off x="1292546" y="3699530"/>
              <a:ext cx="706400" cy="200407"/>
              <a:chOff x="6982893" y="1746749"/>
              <a:chExt cx="586445" cy="200407"/>
            </a:xfrm>
          </p:grpSpPr>
          <p:cxnSp>
            <p:nvCxnSpPr>
              <p:cNvPr id="17" name="Straight Connector 16">
                <a:extLst>
                  <a:ext uri="{FF2B5EF4-FFF2-40B4-BE49-F238E27FC236}">
                    <a16:creationId xmlns:a16="http://schemas.microsoft.com/office/drawing/2014/main" xmlns="" id="{A3DE2E47-0C17-A540-8641-305D28AE43DA}"/>
                  </a:ext>
                </a:extLst>
              </p:cNvPr>
              <p:cNvCxnSpPr/>
              <p:nvPr/>
            </p:nvCxnSpPr>
            <p:spPr>
              <a:xfrm flipH="1" flipV="1">
                <a:off x="6982893" y="1746749"/>
                <a:ext cx="1776" cy="18288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" name="Straight Connector 17">
                <a:extLst>
                  <a:ext uri="{FF2B5EF4-FFF2-40B4-BE49-F238E27FC236}">
                    <a16:creationId xmlns:a16="http://schemas.microsoft.com/office/drawing/2014/main" xmlns="" id="{1CDE18F2-CE2C-7A4C-9E26-D33F38C9E446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987649" y="1857248"/>
                <a:ext cx="186137" cy="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Straight Connector 18">
                <a:extLst>
                  <a:ext uri="{FF2B5EF4-FFF2-40B4-BE49-F238E27FC236}">
                    <a16:creationId xmlns:a16="http://schemas.microsoft.com/office/drawing/2014/main" xmlns="" id="{086DFD5E-F4DC-5841-9000-12CB240BFC11}"/>
                  </a:ext>
                </a:extLst>
              </p:cNvPr>
              <p:cNvCxnSpPr/>
              <p:nvPr/>
            </p:nvCxnSpPr>
            <p:spPr>
              <a:xfrm flipV="1">
                <a:off x="7169568" y="1855716"/>
                <a:ext cx="1060" cy="9144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xmlns="" id="{3D96C33D-087B-BC45-A68D-D240D53133A8}"/>
                  </a:ext>
                </a:extLst>
              </p:cNvPr>
              <p:cNvCxnSpPr/>
              <p:nvPr/>
            </p:nvCxnSpPr>
            <p:spPr>
              <a:xfrm flipV="1">
                <a:off x="7377483" y="1795833"/>
                <a:ext cx="0" cy="9144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xmlns="" id="{76DB7CB1-DA82-4C44-BACD-68EB36A9F166}"/>
                  </a:ext>
                </a:extLst>
              </p:cNvPr>
              <p:cNvCxnSpPr/>
              <p:nvPr/>
            </p:nvCxnSpPr>
            <p:spPr>
              <a:xfrm flipH="1" flipV="1">
                <a:off x="7566358" y="1746751"/>
                <a:ext cx="2980" cy="98477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xmlns="" id="{1E2B9B4E-467B-A64C-B8CE-0D8119FC76C1}"/>
                  </a:ext>
                </a:extLst>
              </p:cNvPr>
              <p:cNvCxnSpPr/>
              <p:nvPr/>
            </p:nvCxnSpPr>
            <p:spPr>
              <a:xfrm flipV="1">
                <a:off x="6988855" y="1795828"/>
                <a:ext cx="396426" cy="57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" name="Straight Connector 22">
                <a:extLst>
                  <a:ext uri="{FF2B5EF4-FFF2-40B4-BE49-F238E27FC236}">
                    <a16:creationId xmlns:a16="http://schemas.microsoft.com/office/drawing/2014/main" xmlns="" id="{EEDB4B3E-C0A0-3C44-A8F8-5E1BE64445ED}"/>
                  </a:ext>
                </a:extLst>
              </p:cNvPr>
              <p:cNvCxnSpPr/>
              <p:nvPr/>
            </p:nvCxnSpPr>
            <p:spPr>
              <a:xfrm>
                <a:off x="6987649" y="1746749"/>
                <a:ext cx="578709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24" name="TextBox 23">
            <a:extLst>
              <a:ext uri="{FF2B5EF4-FFF2-40B4-BE49-F238E27FC236}">
                <a16:creationId xmlns:a16="http://schemas.microsoft.com/office/drawing/2014/main" xmlns="" id="{BFBFE0D9-CD4C-814B-8B96-C37CC59EAE21}"/>
              </a:ext>
            </a:extLst>
          </p:cNvPr>
          <p:cNvSpPr txBox="1"/>
          <p:nvPr/>
        </p:nvSpPr>
        <p:spPr>
          <a:xfrm>
            <a:off x="4605121" y="1735306"/>
            <a:ext cx="228221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45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xmlns="" id="{977B4DAD-E3FC-594D-B5F2-A2CA7DFF4310}"/>
              </a:ext>
            </a:extLst>
          </p:cNvPr>
          <p:cNvSpPr txBox="1"/>
          <p:nvPr/>
        </p:nvSpPr>
        <p:spPr>
          <a:xfrm>
            <a:off x="4930482" y="1690393"/>
            <a:ext cx="228221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45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grpSp>
        <p:nvGrpSpPr>
          <p:cNvPr id="26" name="Group 25">
            <a:extLst>
              <a:ext uri="{FF2B5EF4-FFF2-40B4-BE49-F238E27FC236}">
                <a16:creationId xmlns:a16="http://schemas.microsoft.com/office/drawing/2014/main" xmlns="" id="{F7BE53A3-3265-3C41-AF07-29CB88C6A1A5}"/>
              </a:ext>
            </a:extLst>
          </p:cNvPr>
          <p:cNvGrpSpPr/>
          <p:nvPr/>
        </p:nvGrpSpPr>
        <p:grpSpPr>
          <a:xfrm>
            <a:off x="5929744" y="1712598"/>
            <a:ext cx="1014524" cy="208350"/>
            <a:chOff x="1292546" y="3699530"/>
            <a:chExt cx="706400" cy="277799"/>
          </a:xfrm>
        </p:grpSpPr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xmlns="" id="{6E3AF504-C264-2847-BB2A-DED4F51838A3}"/>
                </a:ext>
              </a:extLst>
            </p:cNvPr>
            <p:cNvSpPr txBox="1"/>
            <p:nvPr/>
          </p:nvSpPr>
          <p:spPr>
            <a:xfrm>
              <a:off x="1403936" y="3761885"/>
              <a:ext cx="15890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tr-TR" sz="450" b="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xmlns="" id="{21E31A8C-78DC-2E4A-AACD-78B37E1D6577}"/>
                </a:ext>
              </a:extLst>
            </p:cNvPr>
            <p:cNvGrpSpPr/>
            <p:nvPr/>
          </p:nvGrpSpPr>
          <p:grpSpPr>
            <a:xfrm>
              <a:off x="1292546" y="3699530"/>
              <a:ext cx="706400" cy="200407"/>
              <a:chOff x="6982893" y="1746749"/>
              <a:chExt cx="586445" cy="200407"/>
            </a:xfrm>
          </p:grpSpPr>
          <p:cxnSp>
            <p:nvCxnSpPr>
              <p:cNvPr id="29" name="Straight Connector 28">
                <a:extLst>
                  <a:ext uri="{FF2B5EF4-FFF2-40B4-BE49-F238E27FC236}">
                    <a16:creationId xmlns:a16="http://schemas.microsoft.com/office/drawing/2014/main" xmlns="" id="{AAA3D987-4521-114E-9C36-0D57B8A56527}"/>
                  </a:ext>
                </a:extLst>
              </p:cNvPr>
              <p:cNvCxnSpPr/>
              <p:nvPr/>
            </p:nvCxnSpPr>
            <p:spPr>
              <a:xfrm flipH="1" flipV="1">
                <a:off x="6982893" y="1746749"/>
                <a:ext cx="1776" cy="18288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0" name="Straight Connector 29">
                <a:extLst>
                  <a:ext uri="{FF2B5EF4-FFF2-40B4-BE49-F238E27FC236}">
                    <a16:creationId xmlns:a16="http://schemas.microsoft.com/office/drawing/2014/main" xmlns="" id="{399225D4-9E77-0841-86FE-6E231F43A425}"/>
                  </a:ext>
                </a:extLst>
              </p:cNvPr>
              <p:cNvCxnSpPr>
                <a:cxnSpLocks/>
              </p:cNvCxnSpPr>
              <p:nvPr/>
            </p:nvCxnSpPr>
            <p:spPr>
              <a:xfrm flipV="1">
                <a:off x="6987649" y="1857248"/>
                <a:ext cx="186137" cy="1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>
                <a:extLst>
                  <a:ext uri="{FF2B5EF4-FFF2-40B4-BE49-F238E27FC236}">
                    <a16:creationId xmlns:a16="http://schemas.microsoft.com/office/drawing/2014/main" xmlns="" id="{7C8BB03A-64D7-B840-9C95-F6FDF620E4F2}"/>
                  </a:ext>
                </a:extLst>
              </p:cNvPr>
              <p:cNvCxnSpPr/>
              <p:nvPr/>
            </p:nvCxnSpPr>
            <p:spPr>
              <a:xfrm flipV="1">
                <a:off x="7169568" y="1855716"/>
                <a:ext cx="1060" cy="9144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>
                <a:extLst>
                  <a:ext uri="{FF2B5EF4-FFF2-40B4-BE49-F238E27FC236}">
                    <a16:creationId xmlns:a16="http://schemas.microsoft.com/office/drawing/2014/main" xmlns="" id="{C1A5C2BC-86FA-B74F-8CEA-9CAA4D2462C7}"/>
                  </a:ext>
                </a:extLst>
              </p:cNvPr>
              <p:cNvCxnSpPr/>
              <p:nvPr/>
            </p:nvCxnSpPr>
            <p:spPr>
              <a:xfrm flipV="1">
                <a:off x="7377483" y="1795833"/>
                <a:ext cx="0" cy="9144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>
                <a:extLst>
                  <a:ext uri="{FF2B5EF4-FFF2-40B4-BE49-F238E27FC236}">
                    <a16:creationId xmlns:a16="http://schemas.microsoft.com/office/drawing/2014/main" xmlns="" id="{618CBF0C-2936-924A-B698-688477BB5575}"/>
                  </a:ext>
                </a:extLst>
              </p:cNvPr>
              <p:cNvCxnSpPr/>
              <p:nvPr/>
            </p:nvCxnSpPr>
            <p:spPr>
              <a:xfrm flipH="1" flipV="1">
                <a:off x="7566358" y="1746751"/>
                <a:ext cx="2980" cy="98477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>
                <a:extLst>
                  <a:ext uri="{FF2B5EF4-FFF2-40B4-BE49-F238E27FC236}">
                    <a16:creationId xmlns:a16="http://schemas.microsoft.com/office/drawing/2014/main" xmlns="" id="{F67B2ECB-6685-AB4B-8814-D9030363DE9C}"/>
                  </a:ext>
                </a:extLst>
              </p:cNvPr>
              <p:cNvCxnSpPr/>
              <p:nvPr/>
            </p:nvCxnSpPr>
            <p:spPr>
              <a:xfrm flipV="1">
                <a:off x="6988855" y="1795828"/>
                <a:ext cx="396426" cy="578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5" name="Straight Connector 34">
                <a:extLst>
                  <a:ext uri="{FF2B5EF4-FFF2-40B4-BE49-F238E27FC236}">
                    <a16:creationId xmlns:a16="http://schemas.microsoft.com/office/drawing/2014/main" xmlns="" id="{9182C1B1-9487-824F-9D2C-462A2ECDA29C}"/>
                  </a:ext>
                </a:extLst>
              </p:cNvPr>
              <p:cNvCxnSpPr/>
              <p:nvPr/>
            </p:nvCxnSpPr>
            <p:spPr>
              <a:xfrm>
                <a:off x="6987649" y="1746749"/>
                <a:ext cx="578709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36" name="TextBox 35">
            <a:extLst>
              <a:ext uri="{FF2B5EF4-FFF2-40B4-BE49-F238E27FC236}">
                <a16:creationId xmlns:a16="http://schemas.microsoft.com/office/drawing/2014/main" xmlns="" id="{75355C4D-C815-BF42-A52C-937F259D9FE0}"/>
              </a:ext>
            </a:extLst>
          </p:cNvPr>
          <p:cNvSpPr txBox="1"/>
          <p:nvPr/>
        </p:nvSpPr>
        <p:spPr>
          <a:xfrm>
            <a:off x="6499640" y="1724398"/>
            <a:ext cx="228221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45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xmlns="" id="{5E2FB375-B925-8B4F-8CA8-B88D5A9E36CA}"/>
              </a:ext>
            </a:extLst>
          </p:cNvPr>
          <p:cNvSpPr txBox="1"/>
          <p:nvPr/>
        </p:nvSpPr>
        <p:spPr>
          <a:xfrm>
            <a:off x="6829707" y="1688426"/>
            <a:ext cx="228221" cy="16158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45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809460135"/>
      </p:ext>
    </p:extLst>
  </p:cSld>
  <p:clrMapOvr>
    <a:masterClrMapping/>
  </p:clrMapOvr>
  <p:transition xmlns:p14="http://schemas.microsoft.com/office/powerpoint/2010/main" spd="med"/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13671966"/>
              </p:ext>
            </p:extLst>
          </p:nvPr>
        </p:nvGraphicFramePr>
        <p:xfrm>
          <a:off x="957449" y="943353"/>
          <a:ext cx="3328789" cy="556391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08080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88262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2432447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133421"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PDH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AGCCACATCGCTCAGACAC-3'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GCCAATACGACCAAATCC-3'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4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′-ACCTTCAAGTTTGTCGTCGTC-3′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′-AACTC TCCCAAAGGGCTATGT-3′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R5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′-AAGACCCTTGTGCTCGTTGT-3′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′-AGGTGGACACAATCCCTCTG-3′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IAP1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GCACGATCTTGTCAGATTGG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GCGGGGAAAGTTGAATATGTA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8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IAP2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CCTGGATAGTCTACTAACTGCC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09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tr-TR" sz="800" b="1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2454" marR="22454" marT="23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TTCTTGCAGAGAGTTTCTGAA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0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XIAP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TCCTGGCGCGAAAAG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1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tr-TR" sz="800" b="1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2454" marR="22454" marT="23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222222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CCAGTGTTGATGCTGAAAC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2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-2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CAGGGCGATGTTGTCCACC-3’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3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GGGGAGGATTGTGGCCTTC-3’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4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CL-xL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GGTCGCATTGTGGCCTTTTTC-3'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5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TGCTGCATTGTTCCCATAGAG-3'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6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cl-1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GCTTCGGAAACTGGACATCA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7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AGCCACAAAGGCACCAAAAG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8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cl-w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GGAGTTCACAGCTCTATAC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19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AAAGGCCCCTACAGTTACCA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0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X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 GGGTGGTTGGGTGAGACTC-3'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1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AGACACGTAAGGAAAACGCATTA-3'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2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im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TCCCTGCTGTCTCGATCCTC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3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tr-TR" sz="800" b="1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2454" marR="22454" marT="23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tr-TR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GTCTTCGGCTGCTTGGTAA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4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RK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AGGTTGGTGAAAACCCTGTG-3'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5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endParaRPr lang="tr-TR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'-GCATTGGGGTGTCTGTTTCT-3'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6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ik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AGACCCTCCTGTATGAGCAG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7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tr-TR" sz="800" b="1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2454" marR="22454" marT="23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ATTCCAAAGAATCGAAGTCCT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8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ad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CCCAGAGTTTGAGCCGAGTG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29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tr-TR" sz="800" b="1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2454" marR="22454" marT="23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CCCATCCCTTCGTCGTCCT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30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ak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TTTTCCGCAGCTACGTTTTT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31"/>
                  </a:ext>
                </a:extLst>
              </a:tr>
              <a:tr h="0">
                <a:tc vMerge="1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tr-TR" sz="800" b="1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2454" marR="22454" marT="23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noProof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AGAGGTAAGGTGACCATCTC-3’</a:t>
                      </a:r>
                    </a:p>
                  </a:txBody>
                  <a:tcPr marL="7144" marR="7144" marT="5358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032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 err="1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Bmf</a:t>
                      </a:r>
                      <a:endParaRPr lang="en-US" sz="600" b="1" noProof="0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AGCCATCTCAGTGTGTGGAG-3’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1016680775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tr-TR" sz="800" b="1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2454" marR="22454" marT="23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CCAGCATTGCCATAAAAGAGTC-3’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2751983902"/>
                  </a:ext>
                </a:extLst>
              </a:tr>
              <a:tr h="133421">
                <a:tc rowSpan="2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uma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F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GACCTCAACGCACAGTACGAG-3’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3872334028"/>
                  </a:ext>
                </a:extLst>
              </a:tr>
              <a:tr h="133421">
                <a:tc vMerge="1"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endParaRPr lang="tr-TR" sz="800" b="1" dirty="0">
                        <a:solidFill>
                          <a:sysClr val="windowText" lastClr="000000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22454" marR="22454" marT="23494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just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600" b="1" noProof="0" dirty="0">
                          <a:solidFill>
                            <a:sysClr val="windowText" lastClr="000000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R</a:t>
                      </a:r>
                    </a:p>
                  </a:txBody>
                  <a:tcPr marL="16841" marR="16841" marT="13216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’-AGGAGTCCCATGATGAGATTGT-3’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xmlns="" val="525190937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7608711" y="5804543"/>
            <a:ext cx="1342034" cy="21929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25" b="1" dirty="0">
                <a:latin typeface="Arial"/>
                <a:cs typeface="Arial"/>
              </a:rPr>
              <a:t>Supplementary Table 1</a:t>
            </a:r>
          </a:p>
        </p:txBody>
      </p:sp>
    </p:spTree>
    <p:extLst>
      <p:ext uri="{BB962C8B-B14F-4D97-AF65-F5344CB8AC3E}">
        <p14:creationId xmlns:p14="http://schemas.microsoft.com/office/powerpoint/2010/main" val="1312976728"/>
      </p:ext>
    </p:extLst>
  </p:cSld>
  <p:clrMapOvr>
    <a:masterClrMapping/>
  </p:clrMapOvr>
  <p:transition xmlns:p14="http://schemas.microsoft.com/office/powerpoint/2010/main" spd="med"/>
</p:sld>
</file>

<file path=ppt/theme/_rels/theme1.x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theme/theme1.xml><?xml version="1.0" encoding="utf-8"?>
<a:theme xmlns:a="http://schemas.openxmlformats.org/drawingml/2006/main" name="Default Theme">
  <a:themeElements>
    <a:clrScheme name="White">
      <a:dk1>
        <a:srgbClr val="000000"/>
      </a:dk1>
      <a:lt1>
        <a:srgbClr val="FFFFFF"/>
      </a:lt1>
      <a:dk2>
        <a:srgbClr val="53585F"/>
      </a:dk2>
      <a:lt2>
        <a:srgbClr val="DCDEE0"/>
      </a:lt2>
      <a:accent1>
        <a:srgbClr val="0365C0"/>
      </a:accent1>
      <a:accent2>
        <a:srgbClr val="00882B"/>
      </a:accent2>
      <a:accent3>
        <a:srgbClr val="DCBD23"/>
      </a:accent3>
      <a:accent4>
        <a:srgbClr val="DE6A10"/>
      </a:accent4>
      <a:accent5>
        <a:srgbClr val="C82506"/>
      </a:accent5>
      <a:accent6>
        <a:srgbClr val="773F9B"/>
      </a:accent6>
      <a:hlink>
        <a:srgbClr val="0000FF"/>
      </a:hlink>
      <a:folHlink>
        <a:srgbClr val="FF00FF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Whit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29999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4999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50800" dist="12700" rotWithShape="0">
              <a:srgbClr val="000000">
                <a:alpha val="50000"/>
              </a:srgbClr>
            </a:outerShdw>
          </a:effectLst>
        </a:effectStyle>
        <a:effectStyle>
          <a:effectLst>
            <a:outerShdw blurRad="38100" dist="25400" dir="5400000" rotWithShape="0">
              <a:srgbClr val="000000">
                <a:alpha val="50000"/>
              </a:srgbClr>
            </a:outerShdw>
          </a:effectLst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blipFill rotWithShape="1">
          <a:blip xmlns:r="http://schemas.openxmlformats.org/officeDocument/2006/relationships" r:embed="rId1"/>
          <a:srcRect/>
          <a:tile tx="0" ty="0" sx="100000" sy="100000" flip="none" algn="tl"/>
        </a:blipFill>
        <a:ln w="12700" cap="flat">
          <a:noFill/>
          <a:miter lim="400000"/>
        </a:ln>
        <a:effectLst>
          <a:outerShdw blurRad="38100" dist="25400" dir="5400000" rotWithShape="0">
            <a:srgbClr val="000000">
              <a:alpha val="50000"/>
            </a:srgbClr>
          </a:outerShdw>
        </a:effectLst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2400" b="0" i="0" u="none" strike="noStrike" cap="none" spc="0" normalizeH="0" baseline="0">
            <a:ln>
              <a:noFill/>
            </a:ln>
            <a:solidFill>
              <a:srgbClr val="FFFFFF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spDef>
    <a:lnDef>
      <a:spPr>
        <a:noFill/>
        <a:ln w="25400" cap="flat">
          <a:solidFill>
            <a:srgbClr val="000000"/>
          </a:solidFill>
          <a:prstDash val="solid"/>
          <a:miter lim="400000"/>
        </a:ln>
        <a:effectLst/>
      </a:spPr>
      <a:bodyPr rot="0" spcFirstLastPara="1" vertOverflow="overflow" horzOverflow="overflow" vert="horz" wrap="square" lIns="91439" tIns="45719" rIns="91439" bIns="45719" numCol="1" spcCol="38100" rtlCol="0" anchor="t">
        <a:noAutofit/>
      </a:bodyPr>
      <a:lstStyle>
        <a:def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lnDef>
    <a:txDef>
      <a:spPr>
        <a:noFill/>
        <a:ln w="12700" cap="flat">
          <a:noFill/>
          <a:miter lim="400000"/>
        </a:ln>
        <a:effectLst/>
      </a:spPr>
      <a:bodyPr rot="0" spcFirstLastPara="1" vertOverflow="overflow" horzOverflow="overflow" vert="horz" wrap="square" lIns="50800" tIns="50800" rIns="50800" bIns="50800" numCol="1" spcCol="38100" rtlCol="0" anchor="ctr">
        <a:spAutoFit/>
      </a:bodyPr>
      <a:lstStyle>
        <a:defPPr marL="0" marR="0" indent="0" algn="ctr" defTabSz="5842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36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  <a:latin typeface="+mn-lt"/>
            <a:ea typeface="+mn-ea"/>
            <a:cs typeface="+mn-cs"/>
            <a:sym typeface="Helvetica Light"/>
          </a:defRPr>
        </a:defPPr>
        <a:lvl1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1pPr>
        <a:lvl2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2pPr>
        <a:lvl3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3pPr>
        <a:lvl4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4pPr>
        <a:lvl5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5pPr>
        <a:lvl6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6pPr>
        <a:lvl7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7pPr>
        <a:lvl8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8pPr>
        <a:lvl9pPr marL="0" marR="0" indent="0" algn="l" defTabSz="914400" rtl="0" fontAlgn="auto" latinLnBrk="1" hangingPunct="0">
          <a:lnSpc>
            <a:spcPct val="100000"/>
          </a:lnSpc>
          <a:spcBef>
            <a:spcPts val="0"/>
          </a:spcBef>
          <a:spcAft>
            <a:spcPts val="0"/>
          </a:spcAft>
          <a:buClrTx/>
          <a:buSzTx/>
          <a:buFontTx/>
          <a:buNone/>
          <a:tabLst/>
          <a:defRPr kumimoji="0" sz="1800" b="0" i="0" u="none" strike="noStrike" cap="none" spc="0" normalizeH="0" baseline="0">
            <a:ln>
              <a:noFill/>
            </a:ln>
            <a:solidFill>
              <a:srgbClr val="000000"/>
            </a:solidFill>
            <a:effectLst/>
            <a:uFillTx/>
          </a:defRPr>
        </a:lvl9pPr>
      </a:lstStyle>
      <a:style>
        <a:lnRef idx="0">
          <a:scrgbClr r="0" g="0" b="0"/>
        </a:lnRef>
        <a:fillRef idx="0">
          <a:scrgbClr r="0" g="0" b="0"/>
        </a:fillRef>
        <a:effectRef idx="0">
          <a:scrgbClr r="0" g="0" b="0"/>
        </a:effectRef>
        <a:fontRef idx="none"/>
      </a:style>
    </a:tx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Default Theme</Template>
  <TotalTime>1304</TotalTime>
  <Words>444</Words>
  <Application>Microsoft Macintosh PowerPoint</Application>
  <PresentationFormat>On-screen Show (4:3)</PresentationFormat>
  <Paragraphs>160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Default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iliz Senbabaoglu</dc:creator>
  <cp:lastModifiedBy>Tugba Bagci</cp:lastModifiedBy>
  <cp:revision>7</cp:revision>
  <dcterms:created xsi:type="dcterms:W3CDTF">2018-05-03T13:36:43Z</dcterms:created>
  <dcterms:modified xsi:type="dcterms:W3CDTF">2018-07-12T10:56:54Z</dcterms:modified>
</cp:coreProperties>
</file>